
<file path=[Content_Types].xml><?xml version="1.0" encoding="utf-8"?>
<Types xmlns="http://schemas.openxmlformats.org/package/2006/content-types">
  <Default Extension="tmp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59" d="100"/>
          <a:sy n="59" d="100"/>
        </p:scale>
        <p:origin x="630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AMILA OSPINA AYALA" userId="78f2fe8b-a352-4d21-8a73-8c582c191c8b" providerId="ADAL" clId="{60061412-3791-4796-9D2B-5B9AAF64AB0F}"/>
    <pc:docChg chg="custSel modSld">
      <pc:chgData name="CAMILA OSPINA AYALA" userId="78f2fe8b-a352-4d21-8a73-8c582c191c8b" providerId="ADAL" clId="{60061412-3791-4796-9D2B-5B9AAF64AB0F}" dt="2022-02-25T11:23:25.067" v="10" actId="167"/>
      <pc:docMkLst>
        <pc:docMk/>
      </pc:docMkLst>
      <pc:sldChg chg="addSp delSp modSp mod">
        <pc:chgData name="CAMILA OSPINA AYALA" userId="78f2fe8b-a352-4d21-8a73-8c582c191c8b" providerId="ADAL" clId="{60061412-3791-4796-9D2B-5B9AAF64AB0F}" dt="2022-02-25T11:23:25.067" v="10" actId="167"/>
        <pc:sldMkLst>
          <pc:docMk/>
          <pc:sldMk cId="3513509246" sldId="256"/>
        </pc:sldMkLst>
        <pc:picChg chg="del">
          <ac:chgData name="CAMILA OSPINA AYALA" userId="78f2fe8b-a352-4d21-8a73-8c582c191c8b" providerId="ADAL" clId="{60061412-3791-4796-9D2B-5B9AAF64AB0F}" dt="2022-02-25T11:22:36.819" v="0" actId="478"/>
          <ac:picMkLst>
            <pc:docMk/>
            <pc:sldMk cId="3513509246" sldId="256"/>
            <ac:picMk id="4" creationId="{E0B5F59A-EC54-4B52-9493-BE67EA709632}"/>
          </ac:picMkLst>
        </pc:picChg>
        <pc:picChg chg="add mod ord">
          <ac:chgData name="CAMILA OSPINA AYALA" userId="78f2fe8b-a352-4d21-8a73-8c582c191c8b" providerId="ADAL" clId="{60061412-3791-4796-9D2B-5B9AAF64AB0F}" dt="2022-02-25T11:23:25.067" v="10" actId="167"/>
          <ac:picMkLst>
            <pc:docMk/>
            <pc:sldMk cId="3513509246" sldId="256"/>
            <ac:picMk id="5" creationId="{9CD7E43F-978E-49CB-B105-04AED7AC3AD5}"/>
          </ac:picMkLst>
        </pc:picChg>
      </pc:sldChg>
    </pc:docChg>
  </pc:docChgLst>
  <pc:docChgLst>
    <pc:chgData name="CAMILA OSPINA AYALA" userId="78f2fe8b-a352-4d21-8a73-8c582c191c8b" providerId="ADAL" clId="{DEA165F4-38F5-4709-B229-2566A93E9A4E}"/>
    <pc:docChg chg="custSel modSld">
      <pc:chgData name="CAMILA OSPINA AYALA" userId="78f2fe8b-a352-4d21-8a73-8c582c191c8b" providerId="ADAL" clId="{DEA165F4-38F5-4709-B229-2566A93E9A4E}" dt="2022-02-24T21:49:06.229" v="26" actId="14100"/>
      <pc:docMkLst>
        <pc:docMk/>
      </pc:docMkLst>
      <pc:sldChg chg="addSp delSp modSp mod">
        <pc:chgData name="CAMILA OSPINA AYALA" userId="78f2fe8b-a352-4d21-8a73-8c582c191c8b" providerId="ADAL" clId="{DEA165F4-38F5-4709-B229-2566A93E9A4E}" dt="2022-02-24T21:49:06.229" v="26" actId="14100"/>
        <pc:sldMkLst>
          <pc:docMk/>
          <pc:sldMk cId="3513509246" sldId="256"/>
        </pc:sldMkLst>
        <pc:picChg chg="add mod">
          <ac:chgData name="CAMILA OSPINA AYALA" userId="78f2fe8b-a352-4d21-8a73-8c582c191c8b" providerId="ADAL" clId="{DEA165F4-38F5-4709-B229-2566A93E9A4E}" dt="2022-02-24T21:49:06.229" v="26" actId="14100"/>
          <ac:picMkLst>
            <pc:docMk/>
            <pc:sldMk cId="3513509246" sldId="256"/>
            <ac:picMk id="4" creationId="{E0B5F59A-EC54-4B52-9493-BE67EA709632}"/>
          </ac:picMkLst>
        </pc:picChg>
        <pc:picChg chg="del">
          <ac:chgData name="CAMILA OSPINA AYALA" userId="78f2fe8b-a352-4d21-8a73-8c582c191c8b" providerId="ADAL" clId="{DEA165F4-38F5-4709-B229-2566A93E9A4E}" dt="2022-02-24T21:41:20.925" v="0" actId="478"/>
          <ac:picMkLst>
            <pc:docMk/>
            <pc:sldMk cId="3513509246" sldId="256"/>
            <ac:picMk id="4" creationId="{E927BDED-F7F8-4118-95A6-5DD1716F8A88}"/>
          </ac:picMkLst>
        </pc:picChg>
        <pc:picChg chg="add del mod">
          <ac:chgData name="CAMILA OSPINA AYALA" userId="78f2fe8b-a352-4d21-8a73-8c582c191c8b" providerId="ADAL" clId="{DEA165F4-38F5-4709-B229-2566A93E9A4E}" dt="2022-02-24T21:41:42.350" v="4" actId="478"/>
          <ac:picMkLst>
            <pc:docMk/>
            <pc:sldMk cId="3513509246" sldId="256"/>
            <ac:picMk id="5" creationId="{A6F3B7B6-7090-4BD1-B720-F09D6EE61641}"/>
          </ac:picMkLst>
        </pc:picChg>
        <pc:picChg chg="add del mod">
          <ac:chgData name="CAMILA OSPINA AYALA" userId="78f2fe8b-a352-4d21-8a73-8c582c191c8b" providerId="ADAL" clId="{DEA165F4-38F5-4709-B229-2566A93E9A4E}" dt="2022-02-24T21:48:21.669" v="17" actId="478"/>
          <ac:picMkLst>
            <pc:docMk/>
            <pc:sldMk cId="3513509246" sldId="256"/>
            <ac:picMk id="7" creationId="{732818A7-685B-4998-A74C-A345B3A68B28}"/>
          </ac:picMkLst>
        </pc:picChg>
      </pc:sldChg>
    </pc:docChg>
  </pc:docChgLst>
  <pc:docChgLst>
    <pc:chgData name="CAMILA OSPINA AYALA" userId="78f2fe8b-a352-4d21-8a73-8c582c191c8b" providerId="ADAL" clId="{9916C4CE-8D47-4DFD-ADA2-B64D33FD19E9}"/>
    <pc:docChg chg="undo custSel modSld">
      <pc:chgData name="CAMILA OSPINA AYALA" userId="78f2fe8b-a352-4d21-8a73-8c582c191c8b" providerId="ADAL" clId="{9916C4CE-8D47-4DFD-ADA2-B64D33FD19E9}" dt="2022-03-05T19:12:07.008" v="6" actId="1076"/>
      <pc:docMkLst>
        <pc:docMk/>
      </pc:docMkLst>
      <pc:sldChg chg="modSp mod">
        <pc:chgData name="CAMILA OSPINA AYALA" userId="78f2fe8b-a352-4d21-8a73-8c582c191c8b" providerId="ADAL" clId="{9916C4CE-8D47-4DFD-ADA2-B64D33FD19E9}" dt="2022-03-05T19:12:07.008" v="6" actId="1076"/>
        <pc:sldMkLst>
          <pc:docMk/>
          <pc:sldMk cId="3513509246" sldId="256"/>
        </pc:sldMkLst>
        <pc:spChg chg="mod">
          <ac:chgData name="CAMILA OSPINA AYALA" userId="78f2fe8b-a352-4d21-8a73-8c582c191c8b" providerId="ADAL" clId="{9916C4CE-8D47-4DFD-ADA2-B64D33FD19E9}" dt="2022-03-05T19:11:59.042" v="4" actId="1076"/>
          <ac:spMkLst>
            <pc:docMk/>
            <pc:sldMk cId="3513509246" sldId="256"/>
            <ac:spMk id="37" creationId="{02E28E87-5820-4DB5-ADD7-7D935FCAD004}"/>
          </ac:spMkLst>
        </pc:spChg>
        <pc:spChg chg="mod">
          <ac:chgData name="CAMILA OSPINA AYALA" userId="78f2fe8b-a352-4d21-8a73-8c582c191c8b" providerId="ADAL" clId="{9916C4CE-8D47-4DFD-ADA2-B64D33FD19E9}" dt="2022-03-05T19:12:07.008" v="6" actId="1076"/>
          <ac:spMkLst>
            <pc:docMk/>
            <pc:sldMk cId="3513509246" sldId="256"/>
            <ac:spMk id="38" creationId="{8119FB29-639F-4F19-A547-8779693A12CE}"/>
          </ac:spMkLst>
        </pc:spChg>
        <pc:spChg chg="mod">
          <ac:chgData name="CAMILA OSPINA AYALA" userId="78f2fe8b-a352-4d21-8a73-8c582c191c8b" providerId="ADAL" clId="{9916C4CE-8D47-4DFD-ADA2-B64D33FD19E9}" dt="2022-03-05T19:12:02.643" v="5" actId="1076"/>
          <ac:spMkLst>
            <pc:docMk/>
            <pc:sldMk cId="3513509246" sldId="256"/>
            <ac:spMk id="39" creationId="{DB5C5379-4487-4E55-9D29-A7F80B84B8E4}"/>
          </ac:spMkLst>
        </pc:spChg>
        <pc:picChg chg="mod">
          <ac:chgData name="CAMILA OSPINA AYALA" userId="78f2fe8b-a352-4d21-8a73-8c582c191c8b" providerId="ADAL" clId="{9916C4CE-8D47-4DFD-ADA2-B64D33FD19E9}" dt="2022-03-05T19:11:54.349" v="3" actId="14100"/>
          <ac:picMkLst>
            <pc:docMk/>
            <pc:sldMk cId="3513509246" sldId="256"/>
            <ac:picMk id="7" creationId="{BD6FC14D-4229-4E51-AF11-1EFC94B3D640}"/>
          </ac:picMkLst>
        </pc:picChg>
      </pc:sldChg>
    </pc:docChg>
  </pc:docChgLst>
  <pc:docChgLst>
    <pc:chgData name="CAMILA OSPINA AYALA" userId="78f2fe8b-a352-4d21-8a73-8c582c191c8b" providerId="ADAL" clId="{C9456DFD-2B99-4C20-9354-113702F89BE9}"/>
    <pc:docChg chg="custSel modSld">
      <pc:chgData name="CAMILA OSPINA AYALA" userId="78f2fe8b-a352-4d21-8a73-8c582c191c8b" providerId="ADAL" clId="{C9456DFD-2B99-4C20-9354-113702F89BE9}" dt="2022-03-02T10:39:11.592" v="26" actId="14100"/>
      <pc:docMkLst>
        <pc:docMk/>
      </pc:docMkLst>
      <pc:sldChg chg="addSp delSp modSp mod">
        <pc:chgData name="CAMILA OSPINA AYALA" userId="78f2fe8b-a352-4d21-8a73-8c582c191c8b" providerId="ADAL" clId="{C9456DFD-2B99-4C20-9354-113702F89BE9}" dt="2022-03-02T10:39:11.592" v="26" actId="14100"/>
        <pc:sldMkLst>
          <pc:docMk/>
          <pc:sldMk cId="3513509246" sldId="256"/>
        </pc:sldMkLst>
        <pc:picChg chg="add del mod ord">
          <ac:chgData name="CAMILA OSPINA AYALA" userId="78f2fe8b-a352-4d21-8a73-8c582c191c8b" providerId="ADAL" clId="{C9456DFD-2B99-4C20-9354-113702F89BE9}" dt="2022-03-02T10:37:25.286" v="13" actId="478"/>
          <ac:picMkLst>
            <pc:docMk/>
            <pc:sldMk cId="3513509246" sldId="256"/>
            <ac:picMk id="4" creationId="{58313F84-236F-4B24-8DFB-60FBEA131F99}"/>
          </ac:picMkLst>
        </pc:picChg>
        <pc:picChg chg="add del mod">
          <ac:chgData name="CAMILA OSPINA AYALA" userId="78f2fe8b-a352-4d21-8a73-8c582c191c8b" providerId="ADAL" clId="{C9456DFD-2B99-4C20-9354-113702F89BE9}" dt="2022-03-02T10:38:13.560" v="17" actId="478"/>
          <ac:picMkLst>
            <pc:docMk/>
            <pc:sldMk cId="3513509246" sldId="256"/>
            <ac:picMk id="5" creationId="{125CB0B7-234B-43A4-A83D-0463019B9616}"/>
          </ac:picMkLst>
        </pc:picChg>
        <pc:picChg chg="del">
          <ac:chgData name="CAMILA OSPINA AYALA" userId="78f2fe8b-a352-4d21-8a73-8c582c191c8b" providerId="ADAL" clId="{C9456DFD-2B99-4C20-9354-113702F89BE9}" dt="2022-03-02T02:55:14.687" v="0" actId="478"/>
          <ac:picMkLst>
            <pc:docMk/>
            <pc:sldMk cId="3513509246" sldId="256"/>
            <ac:picMk id="5" creationId="{9CD7E43F-978E-49CB-B105-04AED7AC3AD5}"/>
          </ac:picMkLst>
        </pc:picChg>
        <pc:picChg chg="add mod ord">
          <ac:chgData name="CAMILA OSPINA AYALA" userId="78f2fe8b-a352-4d21-8a73-8c582c191c8b" providerId="ADAL" clId="{C9456DFD-2B99-4C20-9354-113702F89BE9}" dt="2022-03-02T10:39:11.592" v="26" actId="14100"/>
          <ac:picMkLst>
            <pc:docMk/>
            <pc:sldMk cId="3513509246" sldId="256"/>
            <ac:picMk id="7" creationId="{87477C72-F0F7-4B37-A057-6FF4500B3AC3}"/>
          </ac:picMkLst>
        </pc:picChg>
      </pc:sldChg>
    </pc:docChg>
  </pc:docChgLst>
  <pc:docChgLst>
    <pc:chgData name="CAMILA OSPINA AYALA" userId="78f2fe8b-a352-4d21-8a73-8c582c191c8b" providerId="ADAL" clId="{187911B5-20BD-4C8F-B5D0-28267442506B}"/>
    <pc:docChg chg="undo custSel modSld">
      <pc:chgData name="CAMILA OSPINA AYALA" userId="78f2fe8b-a352-4d21-8a73-8c582c191c8b" providerId="ADAL" clId="{187911B5-20BD-4C8F-B5D0-28267442506B}" dt="2022-02-24T21:33:26.034" v="326" actId="165"/>
      <pc:docMkLst>
        <pc:docMk/>
      </pc:docMkLst>
      <pc:sldChg chg="addSp delSp modSp mod">
        <pc:chgData name="CAMILA OSPINA AYALA" userId="78f2fe8b-a352-4d21-8a73-8c582c191c8b" providerId="ADAL" clId="{187911B5-20BD-4C8F-B5D0-28267442506B}" dt="2022-02-24T21:33:26.034" v="326" actId="165"/>
        <pc:sldMkLst>
          <pc:docMk/>
          <pc:sldMk cId="3513509246" sldId="256"/>
        </pc:sldMkLst>
        <pc:spChg chg="mod">
          <ac:chgData name="CAMILA OSPINA AYALA" userId="78f2fe8b-a352-4d21-8a73-8c582c191c8b" providerId="ADAL" clId="{187911B5-20BD-4C8F-B5D0-28267442506B}" dt="2022-02-24T21:23:24.298" v="14" actId="1076"/>
          <ac:spMkLst>
            <pc:docMk/>
            <pc:sldMk cId="3513509246" sldId="256"/>
            <ac:spMk id="14" creationId="{559545BB-4BA5-4679-B338-FBC782E75B16}"/>
          </ac:spMkLst>
        </pc:spChg>
        <pc:spChg chg="add del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19" creationId="{AC4C3DC5-C950-4469-B152-4E43DE1B5036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21" creationId="{1CA3E8AA-CACE-4939-89EE-2E2C569FA7D2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23" creationId="{2223FC15-4D9E-4B6E-8A58-F6F5B19D2659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25" creationId="{599088B4-5A7A-4909-B659-A569413595EE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26" creationId="{000E1D5E-750D-4A86-887D-B8AE804C8B3B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27" creationId="{EDE3F7CC-9264-4DB8-90A9-8EF5F9D9F236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28" creationId="{4932058E-A20F-4F48-953C-EDBFFCE96125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29" creationId="{5751DFF6-0BE3-49DA-9152-418AC0EC2206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34" creationId="{0CE25098-89F7-4813-B544-78663C75256E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35" creationId="{2843D0DD-7137-4E59-8F50-E9A10B68152C}"/>
          </ac:spMkLst>
        </pc:spChg>
        <pc:grpChg chg="add del mod">
          <ac:chgData name="CAMILA OSPINA AYALA" userId="78f2fe8b-a352-4d21-8a73-8c582c191c8b" providerId="ADAL" clId="{187911B5-20BD-4C8F-B5D0-28267442506B}" dt="2022-02-24T21:30:56.916" v="282" actId="165"/>
          <ac:grpSpMkLst>
            <pc:docMk/>
            <pc:sldMk cId="3513509246" sldId="256"/>
            <ac:grpSpMk id="5" creationId="{006DE612-4C2B-4E1B-B82E-F339281C75D5}"/>
          </ac:grpSpMkLst>
        </pc:grpChg>
        <pc:grpChg chg="add del mod">
          <ac:chgData name="CAMILA OSPINA AYALA" userId="78f2fe8b-a352-4d21-8a73-8c582c191c8b" providerId="ADAL" clId="{187911B5-20BD-4C8F-B5D0-28267442506B}" dt="2022-02-24T21:32:43.805" v="316" actId="165"/>
          <ac:grpSpMkLst>
            <pc:docMk/>
            <pc:sldMk cId="3513509246" sldId="256"/>
            <ac:grpSpMk id="6" creationId="{A0A96CC2-E922-4833-B114-2553F37C9A33}"/>
          </ac:grpSpMkLst>
        </pc:grpChg>
        <pc:grpChg chg="add del mod">
          <ac:chgData name="CAMILA OSPINA AYALA" userId="78f2fe8b-a352-4d21-8a73-8c582c191c8b" providerId="ADAL" clId="{187911B5-20BD-4C8F-B5D0-28267442506B}" dt="2022-02-24T21:33:26.034" v="326" actId="165"/>
          <ac:grpSpMkLst>
            <pc:docMk/>
            <pc:sldMk cId="3513509246" sldId="256"/>
            <ac:grpSpMk id="7" creationId="{70B8AE92-9F7E-43B5-9888-4C997963DB39}"/>
          </ac:grpSpMkLst>
        </pc:grpChg>
        <pc:picChg chg="add mod modCrop">
          <ac:chgData name="CAMILA OSPINA AYALA" userId="78f2fe8b-a352-4d21-8a73-8c582c191c8b" providerId="ADAL" clId="{187911B5-20BD-4C8F-B5D0-28267442506B}" dt="2022-02-24T21:32:03.241" v="310" actId="1076"/>
          <ac:picMkLst>
            <pc:docMk/>
            <pc:sldMk cId="3513509246" sldId="256"/>
            <ac:picMk id="4" creationId="{E927BDED-F7F8-4118-95A6-5DD1716F8A88}"/>
          </ac:picMkLst>
        </pc:picChg>
        <pc:picChg chg="del">
          <ac:chgData name="CAMILA OSPINA AYALA" userId="78f2fe8b-a352-4d21-8a73-8c582c191c8b" providerId="ADAL" clId="{187911B5-20BD-4C8F-B5D0-28267442506B}" dt="2022-02-24T21:21:00.561" v="1" actId="478"/>
          <ac:picMkLst>
            <pc:docMk/>
            <pc:sldMk cId="3513509246" sldId="256"/>
            <ac:picMk id="13" creationId="{3528E06E-326A-4332-977C-BC054873EE2B}"/>
          </ac:picMkLst>
        </pc:picChg>
        <pc:picChg chg="add del mod modCrop">
          <ac:chgData name="CAMILA OSPINA AYALA" userId="78f2fe8b-a352-4d21-8a73-8c582c191c8b" providerId="ADAL" clId="{187911B5-20BD-4C8F-B5D0-28267442506B}" dt="2022-02-24T21:21:40.512" v="13" actId="478"/>
          <ac:picMkLst>
            <pc:docMk/>
            <pc:sldMk cId="3513509246" sldId="256"/>
            <ac:picMk id="17" creationId="{618A0970-9F8E-486E-9464-E7FFFE0AADF9}"/>
          </ac:picMkLst>
        </pc:picChg>
      </pc:sldChg>
    </pc:docChg>
  </pc:docChgLst>
  <pc:docChgLst>
    <pc:chgData name="CAMILA OSPINA AYALA" userId="78f2fe8b-a352-4d21-8a73-8c582c191c8b" providerId="ADAL" clId="{045262AA-3CDD-44FA-8FDD-B4A21D74F4F7}"/>
    <pc:docChg chg="undo custSel modSld">
      <pc:chgData name="CAMILA OSPINA AYALA" userId="78f2fe8b-a352-4d21-8a73-8c582c191c8b" providerId="ADAL" clId="{045262AA-3CDD-44FA-8FDD-B4A21D74F4F7}" dt="2022-03-02T19:07:41.147" v="155" actId="20577"/>
      <pc:docMkLst>
        <pc:docMk/>
      </pc:docMkLst>
      <pc:sldChg chg="addSp delSp modSp mod">
        <pc:chgData name="CAMILA OSPINA AYALA" userId="78f2fe8b-a352-4d21-8a73-8c582c191c8b" providerId="ADAL" clId="{045262AA-3CDD-44FA-8FDD-B4A21D74F4F7}" dt="2022-03-02T19:07:41.147" v="155" actId="20577"/>
        <pc:sldMkLst>
          <pc:docMk/>
          <pc:sldMk cId="3513509246" sldId="256"/>
        </pc:sldMkLst>
        <pc:spChg chg="add del mod">
          <ac:chgData name="CAMILA OSPINA AYALA" userId="78f2fe8b-a352-4d21-8a73-8c582c191c8b" providerId="ADAL" clId="{045262AA-3CDD-44FA-8FDD-B4A21D74F4F7}" dt="2022-03-02T10:57:14.238" v="75"/>
          <ac:spMkLst>
            <pc:docMk/>
            <pc:sldMk cId="3513509246" sldId="256"/>
            <ac:spMk id="5" creationId="{0E538BAC-48E6-4FB4-BA4E-21F8528DE263}"/>
          </ac:spMkLst>
        </pc:spChg>
        <pc:spChg chg="mod">
          <ac:chgData name="CAMILA OSPINA AYALA" userId="78f2fe8b-a352-4d21-8a73-8c582c191c8b" providerId="ADAL" clId="{045262AA-3CDD-44FA-8FDD-B4A21D74F4F7}" dt="2022-03-02T10:56:22.261" v="62" actId="255"/>
          <ac:spMkLst>
            <pc:docMk/>
            <pc:sldMk cId="3513509246" sldId="256"/>
            <ac:spMk id="14" creationId="{559545BB-4BA5-4679-B338-FBC782E75B16}"/>
          </ac:spMkLst>
        </pc:spChg>
        <pc:spChg chg="mod">
          <ac:chgData name="CAMILA OSPINA AYALA" userId="78f2fe8b-a352-4d21-8a73-8c582c191c8b" providerId="ADAL" clId="{045262AA-3CDD-44FA-8FDD-B4A21D74F4F7}" dt="2022-03-02T10:55:49.850" v="55" actId="165"/>
          <ac:spMkLst>
            <pc:docMk/>
            <pc:sldMk cId="3513509246" sldId="256"/>
            <ac:spMk id="19" creationId="{AC4C3DC5-C950-4469-B152-4E43DE1B5036}"/>
          </ac:spMkLst>
        </pc:spChg>
        <pc:spChg chg="mod">
          <ac:chgData name="CAMILA OSPINA AYALA" userId="78f2fe8b-a352-4d21-8a73-8c582c191c8b" providerId="ADAL" clId="{045262AA-3CDD-44FA-8FDD-B4A21D74F4F7}" dt="2022-03-02T10:55:49.850" v="55" actId="165"/>
          <ac:spMkLst>
            <pc:docMk/>
            <pc:sldMk cId="3513509246" sldId="256"/>
            <ac:spMk id="21" creationId="{1CA3E8AA-CACE-4939-89EE-2E2C569FA7D2}"/>
          </ac:spMkLst>
        </pc:spChg>
        <pc:spChg chg="mod">
          <ac:chgData name="CAMILA OSPINA AYALA" userId="78f2fe8b-a352-4d21-8a73-8c582c191c8b" providerId="ADAL" clId="{045262AA-3CDD-44FA-8FDD-B4A21D74F4F7}" dt="2022-03-02T10:55:49.850" v="55" actId="165"/>
          <ac:spMkLst>
            <pc:docMk/>
            <pc:sldMk cId="3513509246" sldId="256"/>
            <ac:spMk id="23" creationId="{2223FC15-4D9E-4B6E-8A58-F6F5B19D2659}"/>
          </ac:spMkLst>
        </pc:spChg>
        <pc:spChg chg="mod">
          <ac:chgData name="CAMILA OSPINA AYALA" userId="78f2fe8b-a352-4d21-8a73-8c582c191c8b" providerId="ADAL" clId="{045262AA-3CDD-44FA-8FDD-B4A21D74F4F7}" dt="2022-03-02T10:55:49.850" v="55" actId="165"/>
          <ac:spMkLst>
            <pc:docMk/>
            <pc:sldMk cId="3513509246" sldId="256"/>
            <ac:spMk id="25" creationId="{599088B4-5A7A-4909-B659-A569413595EE}"/>
          </ac:spMkLst>
        </pc:spChg>
        <pc:spChg chg="mod">
          <ac:chgData name="CAMILA OSPINA AYALA" userId="78f2fe8b-a352-4d21-8a73-8c582c191c8b" providerId="ADAL" clId="{045262AA-3CDD-44FA-8FDD-B4A21D74F4F7}" dt="2022-03-02T10:55:49.850" v="55" actId="165"/>
          <ac:spMkLst>
            <pc:docMk/>
            <pc:sldMk cId="3513509246" sldId="256"/>
            <ac:spMk id="26" creationId="{000E1D5E-750D-4A86-887D-B8AE804C8B3B}"/>
          </ac:spMkLst>
        </pc:spChg>
        <pc:spChg chg="mod">
          <ac:chgData name="CAMILA OSPINA AYALA" userId="78f2fe8b-a352-4d21-8a73-8c582c191c8b" providerId="ADAL" clId="{045262AA-3CDD-44FA-8FDD-B4A21D74F4F7}" dt="2022-03-02T10:55:49.850" v="55" actId="165"/>
          <ac:spMkLst>
            <pc:docMk/>
            <pc:sldMk cId="3513509246" sldId="256"/>
            <ac:spMk id="27" creationId="{EDE3F7CC-9264-4DB8-90A9-8EF5F9D9F236}"/>
          </ac:spMkLst>
        </pc:spChg>
        <pc:spChg chg="mod">
          <ac:chgData name="CAMILA OSPINA AYALA" userId="78f2fe8b-a352-4d21-8a73-8c582c191c8b" providerId="ADAL" clId="{045262AA-3CDD-44FA-8FDD-B4A21D74F4F7}" dt="2022-03-02T10:55:49.850" v="55" actId="165"/>
          <ac:spMkLst>
            <pc:docMk/>
            <pc:sldMk cId="3513509246" sldId="256"/>
            <ac:spMk id="28" creationId="{4932058E-A20F-4F48-953C-EDBFFCE96125}"/>
          </ac:spMkLst>
        </pc:spChg>
        <pc:spChg chg="mod">
          <ac:chgData name="CAMILA OSPINA AYALA" userId="78f2fe8b-a352-4d21-8a73-8c582c191c8b" providerId="ADAL" clId="{045262AA-3CDD-44FA-8FDD-B4A21D74F4F7}" dt="2022-03-02T10:55:49.850" v="55" actId="165"/>
          <ac:spMkLst>
            <pc:docMk/>
            <pc:sldMk cId="3513509246" sldId="256"/>
            <ac:spMk id="29" creationId="{5751DFF6-0BE3-49DA-9152-418AC0EC2206}"/>
          </ac:spMkLst>
        </pc:spChg>
        <pc:spChg chg="mod">
          <ac:chgData name="CAMILA OSPINA AYALA" userId="78f2fe8b-a352-4d21-8a73-8c582c191c8b" providerId="ADAL" clId="{045262AA-3CDD-44FA-8FDD-B4A21D74F4F7}" dt="2022-03-02T10:56:22.261" v="62" actId="255"/>
          <ac:spMkLst>
            <pc:docMk/>
            <pc:sldMk cId="3513509246" sldId="256"/>
            <ac:spMk id="30" creationId="{F3C4E3DD-1D10-4D5A-81CD-763ECE650A65}"/>
          </ac:spMkLst>
        </pc:spChg>
        <pc:spChg chg="mod">
          <ac:chgData name="CAMILA OSPINA AYALA" userId="78f2fe8b-a352-4d21-8a73-8c582c191c8b" providerId="ADAL" clId="{045262AA-3CDD-44FA-8FDD-B4A21D74F4F7}" dt="2022-03-02T10:56:22.261" v="62" actId="255"/>
          <ac:spMkLst>
            <pc:docMk/>
            <pc:sldMk cId="3513509246" sldId="256"/>
            <ac:spMk id="31" creationId="{07AE9398-1881-469F-951D-29ADA2B178B6}"/>
          </ac:spMkLst>
        </pc:spChg>
        <pc:spChg chg="mod">
          <ac:chgData name="CAMILA OSPINA AYALA" userId="78f2fe8b-a352-4d21-8a73-8c582c191c8b" providerId="ADAL" clId="{045262AA-3CDD-44FA-8FDD-B4A21D74F4F7}" dt="2022-03-02T10:56:22.261" v="62" actId="255"/>
          <ac:spMkLst>
            <pc:docMk/>
            <pc:sldMk cId="3513509246" sldId="256"/>
            <ac:spMk id="32" creationId="{F663FA82-1B76-4B5E-939C-AED05F0BEF2C}"/>
          </ac:spMkLst>
        </pc:spChg>
        <pc:spChg chg="mod">
          <ac:chgData name="CAMILA OSPINA AYALA" userId="78f2fe8b-a352-4d21-8a73-8c582c191c8b" providerId="ADAL" clId="{045262AA-3CDD-44FA-8FDD-B4A21D74F4F7}" dt="2022-03-02T10:56:22.261" v="62" actId="255"/>
          <ac:spMkLst>
            <pc:docMk/>
            <pc:sldMk cId="3513509246" sldId="256"/>
            <ac:spMk id="33" creationId="{44C6A6F1-68BE-4290-B0AA-CE94068E701A}"/>
          </ac:spMkLst>
        </pc:spChg>
        <pc:spChg chg="mod">
          <ac:chgData name="CAMILA OSPINA AYALA" userId="78f2fe8b-a352-4d21-8a73-8c582c191c8b" providerId="ADAL" clId="{045262AA-3CDD-44FA-8FDD-B4A21D74F4F7}" dt="2022-03-02T10:56:16.443" v="61" actId="14100"/>
          <ac:spMkLst>
            <pc:docMk/>
            <pc:sldMk cId="3513509246" sldId="256"/>
            <ac:spMk id="34" creationId="{0CE25098-89F7-4813-B544-78663C75256E}"/>
          </ac:spMkLst>
        </pc:spChg>
        <pc:spChg chg="mod">
          <ac:chgData name="CAMILA OSPINA AYALA" userId="78f2fe8b-a352-4d21-8a73-8c582c191c8b" providerId="ADAL" clId="{045262AA-3CDD-44FA-8FDD-B4A21D74F4F7}" dt="2022-03-02T10:55:49.850" v="55" actId="165"/>
          <ac:spMkLst>
            <pc:docMk/>
            <pc:sldMk cId="3513509246" sldId="256"/>
            <ac:spMk id="35" creationId="{2843D0DD-7137-4E59-8F50-E9A10B68152C}"/>
          </ac:spMkLst>
        </pc:spChg>
        <pc:spChg chg="add mod">
          <ac:chgData name="CAMILA OSPINA AYALA" userId="78f2fe8b-a352-4d21-8a73-8c582c191c8b" providerId="ADAL" clId="{045262AA-3CDD-44FA-8FDD-B4A21D74F4F7}" dt="2022-03-02T19:07:41.147" v="155" actId="20577"/>
          <ac:spMkLst>
            <pc:docMk/>
            <pc:sldMk cId="3513509246" sldId="256"/>
            <ac:spMk id="36" creationId="{DC069024-5794-4467-8B1E-907245A4886B}"/>
          </ac:spMkLst>
        </pc:spChg>
        <pc:spChg chg="add mod">
          <ac:chgData name="CAMILA OSPINA AYALA" userId="78f2fe8b-a352-4d21-8a73-8c582c191c8b" providerId="ADAL" clId="{045262AA-3CDD-44FA-8FDD-B4A21D74F4F7}" dt="2022-03-02T18:29:25.816" v="145"/>
          <ac:spMkLst>
            <pc:docMk/>
            <pc:sldMk cId="3513509246" sldId="256"/>
            <ac:spMk id="37" creationId="{02E28E87-5820-4DB5-ADD7-7D935FCAD004}"/>
          </ac:spMkLst>
        </pc:spChg>
        <pc:spChg chg="add mod">
          <ac:chgData name="CAMILA OSPINA AYALA" userId="78f2fe8b-a352-4d21-8a73-8c582c191c8b" providerId="ADAL" clId="{045262AA-3CDD-44FA-8FDD-B4A21D74F4F7}" dt="2022-03-02T18:29:57.144" v="147"/>
          <ac:spMkLst>
            <pc:docMk/>
            <pc:sldMk cId="3513509246" sldId="256"/>
            <ac:spMk id="38" creationId="{8119FB29-639F-4F19-A547-8779693A12CE}"/>
          </ac:spMkLst>
        </pc:spChg>
        <pc:spChg chg="add mod">
          <ac:chgData name="CAMILA OSPINA AYALA" userId="78f2fe8b-a352-4d21-8a73-8c582c191c8b" providerId="ADAL" clId="{045262AA-3CDD-44FA-8FDD-B4A21D74F4F7}" dt="2022-03-02T18:30:15.219" v="154" actId="20577"/>
          <ac:spMkLst>
            <pc:docMk/>
            <pc:sldMk cId="3513509246" sldId="256"/>
            <ac:spMk id="39" creationId="{DB5C5379-4487-4E55-9D29-A7F80B84B8E4}"/>
          </ac:spMkLst>
        </pc:spChg>
        <pc:spChg chg="mod">
          <ac:chgData name="CAMILA OSPINA AYALA" userId="78f2fe8b-a352-4d21-8a73-8c582c191c8b" providerId="ADAL" clId="{045262AA-3CDD-44FA-8FDD-B4A21D74F4F7}" dt="2022-03-02T16:40:17.640" v="78"/>
          <ac:spMkLst>
            <pc:docMk/>
            <pc:sldMk cId="3513509246" sldId="256"/>
            <ac:spMk id="41" creationId="{CD7D6E72-2DF3-433C-9245-B8D06A8F6882}"/>
          </ac:spMkLst>
        </pc:spChg>
        <pc:spChg chg="mod">
          <ac:chgData name="CAMILA OSPINA AYALA" userId="78f2fe8b-a352-4d21-8a73-8c582c191c8b" providerId="ADAL" clId="{045262AA-3CDD-44FA-8FDD-B4A21D74F4F7}" dt="2022-03-02T16:40:17.640" v="78"/>
          <ac:spMkLst>
            <pc:docMk/>
            <pc:sldMk cId="3513509246" sldId="256"/>
            <ac:spMk id="42" creationId="{9AA6E116-2287-49D9-9935-F5F1399D22C0}"/>
          </ac:spMkLst>
        </pc:spChg>
        <pc:spChg chg="add mod">
          <ac:chgData name="CAMILA OSPINA AYALA" userId="78f2fe8b-a352-4d21-8a73-8c582c191c8b" providerId="ADAL" clId="{045262AA-3CDD-44FA-8FDD-B4A21D74F4F7}" dt="2022-03-02T17:01:35.957" v="135" actId="164"/>
          <ac:spMkLst>
            <pc:docMk/>
            <pc:sldMk cId="3513509246" sldId="256"/>
            <ac:spMk id="43" creationId="{E45EC198-C866-4132-8737-8E00EC3FB61B}"/>
          </ac:spMkLst>
        </pc:spChg>
        <pc:spChg chg="add del mod">
          <ac:chgData name="CAMILA OSPINA AYALA" userId="78f2fe8b-a352-4d21-8a73-8c582c191c8b" providerId="ADAL" clId="{045262AA-3CDD-44FA-8FDD-B4A21D74F4F7}" dt="2022-03-02T16:52:24.305" v="99"/>
          <ac:spMkLst>
            <pc:docMk/>
            <pc:sldMk cId="3513509246" sldId="256"/>
            <ac:spMk id="44" creationId="{A11D9A51-38C1-4066-96A8-F9E51A3E197C}"/>
          </ac:spMkLst>
        </pc:spChg>
        <pc:spChg chg="add del mod">
          <ac:chgData name="CAMILA OSPINA AYALA" userId="78f2fe8b-a352-4d21-8a73-8c582c191c8b" providerId="ADAL" clId="{045262AA-3CDD-44FA-8FDD-B4A21D74F4F7}" dt="2022-03-02T16:52:27.263" v="101"/>
          <ac:spMkLst>
            <pc:docMk/>
            <pc:sldMk cId="3513509246" sldId="256"/>
            <ac:spMk id="45" creationId="{ECC421A9-8C91-4500-A114-AB9A4E1359CA}"/>
          </ac:spMkLst>
        </pc:spChg>
        <pc:spChg chg="add mod">
          <ac:chgData name="CAMILA OSPINA AYALA" userId="78f2fe8b-a352-4d21-8a73-8c582c191c8b" providerId="ADAL" clId="{045262AA-3CDD-44FA-8FDD-B4A21D74F4F7}" dt="2022-03-02T17:01:35.957" v="135" actId="164"/>
          <ac:spMkLst>
            <pc:docMk/>
            <pc:sldMk cId="3513509246" sldId="256"/>
            <ac:spMk id="46" creationId="{302F2040-E254-43B0-9DC5-4316B611DD09}"/>
          </ac:spMkLst>
        </pc:spChg>
        <pc:spChg chg="add mod">
          <ac:chgData name="CAMILA OSPINA AYALA" userId="78f2fe8b-a352-4d21-8a73-8c582c191c8b" providerId="ADAL" clId="{045262AA-3CDD-44FA-8FDD-B4A21D74F4F7}" dt="2022-03-02T17:01:35.957" v="135" actId="164"/>
          <ac:spMkLst>
            <pc:docMk/>
            <pc:sldMk cId="3513509246" sldId="256"/>
            <ac:spMk id="47" creationId="{5B996910-14B2-4F10-96FB-7F5F045FCD23}"/>
          </ac:spMkLst>
        </pc:spChg>
        <pc:spChg chg="mod">
          <ac:chgData name="CAMILA OSPINA AYALA" userId="78f2fe8b-a352-4d21-8a73-8c582c191c8b" providerId="ADAL" clId="{045262AA-3CDD-44FA-8FDD-B4A21D74F4F7}" dt="2022-03-02T16:53:59.567" v="121"/>
          <ac:spMkLst>
            <pc:docMk/>
            <pc:sldMk cId="3513509246" sldId="256"/>
            <ac:spMk id="50" creationId="{095FBAFF-2BA5-4DC5-B43B-CCE10A115593}"/>
          </ac:spMkLst>
        </pc:spChg>
        <pc:spChg chg="mod">
          <ac:chgData name="CAMILA OSPINA AYALA" userId="78f2fe8b-a352-4d21-8a73-8c582c191c8b" providerId="ADAL" clId="{045262AA-3CDD-44FA-8FDD-B4A21D74F4F7}" dt="2022-03-02T16:53:59.567" v="121"/>
          <ac:spMkLst>
            <pc:docMk/>
            <pc:sldMk cId="3513509246" sldId="256"/>
            <ac:spMk id="51" creationId="{A6386923-FE86-4730-A40D-E071502B8622}"/>
          </ac:spMkLst>
        </pc:spChg>
        <pc:spChg chg="mod">
          <ac:chgData name="CAMILA OSPINA AYALA" userId="78f2fe8b-a352-4d21-8a73-8c582c191c8b" providerId="ADAL" clId="{045262AA-3CDD-44FA-8FDD-B4A21D74F4F7}" dt="2022-03-02T16:53:59.567" v="121"/>
          <ac:spMkLst>
            <pc:docMk/>
            <pc:sldMk cId="3513509246" sldId="256"/>
            <ac:spMk id="57" creationId="{BCCF56B5-13FF-44B8-92B7-0782234BB65A}"/>
          </ac:spMkLst>
        </pc:spChg>
        <pc:spChg chg="mod">
          <ac:chgData name="CAMILA OSPINA AYALA" userId="78f2fe8b-a352-4d21-8a73-8c582c191c8b" providerId="ADAL" clId="{045262AA-3CDD-44FA-8FDD-B4A21D74F4F7}" dt="2022-03-02T16:53:59.567" v="121"/>
          <ac:spMkLst>
            <pc:docMk/>
            <pc:sldMk cId="3513509246" sldId="256"/>
            <ac:spMk id="58" creationId="{F59E6A1B-6E37-40D0-B4A5-E1E745356E2F}"/>
          </ac:spMkLst>
        </pc:spChg>
        <pc:spChg chg="mod">
          <ac:chgData name="CAMILA OSPINA AYALA" userId="78f2fe8b-a352-4d21-8a73-8c582c191c8b" providerId="ADAL" clId="{045262AA-3CDD-44FA-8FDD-B4A21D74F4F7}" dt="2022-03-02T16:53:59.567" v="121"/>
          <ac:spMkLst>
            <pc:docMk/>
            <pc:sldMk cId="3513509246" sldId="256"/>
            <ac:spMk id="59" creationId="{B7A647EC-8363-4802-B2B3-9A3E77547E8B}"/>
          </ac:spMkLst>
        </pc:spChg>
        <pc:spChg chg="mod">
          <ac:chgData name="CAMILA OSPINA AYALA" userId="78f2fe8b-a352-4d21-8a73-8c582c191c8b" providerId="ADAL" clId="{045262AA-3CDD-44FA-8FDD-B4A21D74F4F7}" dt="2022-03-02T16:53:59.567" v="121"/>
          <ac:spMkLst>
            <pc:docMk/>
            <pc:sldMk cId="3513509246" sldId="256"/>
            <ac:spMk id="60" creationId="{5C899AE7-7B7A-4281-B07B-901FF01D588E}"/>
          </ac:spMkLst>
        </pc:spChg>
        <pc:spChg chg="mod">
          <ac:chgData name="CAMILA OSPINA AYALA" userId="78f2fe8b-a352-4d21-8a73-8c582c191c8b" providerId="ADAL" clId="{045262AA-3CDD-44FA-8FDD-B4A21D74F4F7}" dt="2022-03-02T16:53:59.567" v="121"/>
          <ac:spMkLst>
            <pc:docMk/>
            <pc:sldMk cId="3513509246" sldId="256"/>
            <ac:spMk id="62" creationId="{1CBA7B8D-42D1-4760-B704-6EF1D3205C29}"/>
          </ac:spMkLst>
        </pc:spChg>
        <pc:grpChg chg="add mod topLvl">
          <ac:chgData name="CAMILA OSPINA AYALA" userId="78f2fe8b-a352-4d21-8a73-8c582c191c8b" providerId="ADAL" clId="{045262AA-3CDD-44FA-8FDD-B4A21D74F4F7}" dt="2022-03-02T17:22:51.381" v="140" actId="14100"/>
          <ac:grpSpMkLst>
            <pc:docMk/>
            <pc:sldMk cId="3513509246" sldId="256"/>
            <ac:grpSpMk id="2" creationId="{6927146B-06B4-41B4-AD3D-AA0F2FB64A1B}"/>
          </ac:grpSpMkLst>
        </pc:grpChg>
        <pc:grpChg chg="add del mod">
          <ac:chgData name="CAMILA OSPINA AYALA" userId="78f2fe8b-a352-4d21-8a73-8c582c191c8b" providerId="ADAL" clId="{045262AA-3CDD-44FA-8FDD-B4A21D74F4F7}" dt="2022-03-02T10:55:49.850" v="55" actId="165"/>
          <ac:grpSpMkLst>
            <pc:docMk/>
            <pc:sldMk cId="3513509246" sldId="256"/>
            <ac:grpSpMk id="4" creationId="{DC2369D1-6D56-482A-ADFF-DEBD9D185D54}"/>
          </ac:grpSpMkLst>
        </pc:grpChg>
        <pc:grpChg chg="add mod">
          <ac:chgData name="CAMILA OSPINA AYALA" userId="78f2fe8b-a352-4d21-8a73-8c582c191c8b" providerId="ADAL" clId="{045262AA-3CDD-44FA-8FDD-B4A21D74F4F7}" dt="2022-03-02T17:01:47.137" v="137" actId="14100"/>
          <ac:grpSpMkLst>
            <pc:docMk/>
            <pc:sldMk cId="3513509246" sldId="256"/>
            <ac:grpSpMk id="8" creationId="{D817D991-9593-4D73-8A00-9379779F553F}"/>
          </ac:grpSpMkLst>
        </pc:grpChg>
        <pc:grpChg chg="mod">
          <ac:chgData name="CAMILA OSPINA AYALA" userId="78f2fe8b-a352-4d21-8a73-8c582c191c8b" providerId="ADAL" clId="{045262AA-3CDD-44FA-8FDD-B4A21D74F4F7}" dt="2022-03-02T10:55:49.850" v="55" actId="165"/>
          <ac:grpSpMkLst>
            <pc:docMk/>
            <pc:sldMk cId="3513509246" sldId="256"/>
            <ac:grpSpMk id="15" creationId="{7E83C65F-6016-4224-B46D-4B3AC52081C9}"/>
          </ac:grpSpMkLst>
        </pc:grpChg>
        <pc:grpChg chg="del mod topLvl">
          <ac:chgData name="CAMILA OSPINA AYALA" userId="78f2fe8b-a352-4d21-8a73-8c582c191c8b" providerId="ADAL" clId="{045262AA-3CDD-44FA-8FDD-B4A21D74F4F7}" dt="2022-03-02T16:53:59.204" v="120" actId="478"/>
          <ac:grpSpMkLst>
            <pc:docMk/>
            <pc:sldMk cId="3513509246" sldId="256"/>
            <ac:grpSpMk id="16" creationId="{5BD62117-51CC-49FD-9B14-D0BD3D7E5606}"/>
          </ac:grpSpMkLst>
        </pc:grpChg>
        <pc:grpChg chg="add del mod">
          <ac:chgData name="CAMILA OSPINA AYALA" userId="78f2fe8b-a352-4d21-8a73-8c582c191c8b" providerId="ADAL" clId="{045262AA-3CDD-44FA-8FDD-B4A21D74F4F7}" dt="2022-03-02T16:40:19.107" v="79"/>
          <ac:grpSpMkLst>
            <pc:docMk/>
            <pc:sldMk cId="3513509246" sldId="256"/>
            <ac:grpSpMk id="38" creationId="{56072A00-B24D-4377-8CB9-DB0517C2CC61}"/>
          </ac:grpSpMkLst>
        </pc:grpChg>
        <pc:grpChg chg="add mod">
          <ac:chgData name="CAMILA OSPINA AYALA" userId="78f2fe8b-a352-4d21-8a73-8c582c191c8b" providerId="ADAL" clId="{045262AA-3CDD-44FA-8FDD-B4A21D74F4F7}" dt="2022-03-02T16:54:09.077" v="124" actId="1076"/>
          <ac:grpSpMkLst>
            <pc:docMk/>
            <pc:sldMk cId="3513509246" sldId="256"/>
            <ac:grpSpMk id="48" creationId="{AE8D2A32-11F0-447F-974B-D46D081BB987}"/>
          </ac:grpSpMkLst>
        </pc:grpChg>
        <pc:grpChg chg="mod">
          <ac:chgData name="CAMILA OSPINA AYALA" userId="78f2fe8b-a352-4d21-8a73-8c582c191c8b" providerId="ADAL" clId="{045262AA-3CDD-44FA-8FDD-B4A21D74F4F7}" dt="2022-03-02T16:53:59.567" v="121"/>
          <ac:grpSpMkLst>
            <pc:docMk/>
            <pc:sldMk cId="3513509246" sldId="256"/>
            <ac:grpSpMk id="49" creationId="{EFB2301E-53EC-495F-8EC8-04A68FE9C76F}"/>
          </ac:grpSpMkLst>
        </pc:grpChg>
        <pc:grpChg chg="mod">
          <ac:chgData name="CAMILA OSPINA AYALA" userId="78f2fe8b-a352-4d21-8a73-8c582c191c8b" providerId="ADAL" clId="{045262AA-3CDD-44FA-8FDD-B4A21D74F4F7}" dt="2022-03-02T16:53:59.567" v="121"/>
          <ac:grpSpMkLst>
            <pc:docMk/>
            <pc:sldMk cId="3513509246" sldId="256"/>
            <ac:grpSpMk id="53" creationId="{5FD2E280-7A6B-4620-9AE8-07898E160FD0}"/>
          </ac:grpSpMkLst>
        </pc:grpChg>
        <pc:picChg chg="mod">
          <ac:chgData name="CAMILA OSPINA AYALA" userId="78f2fe8b-a352-4d21-8a73-8c582c191c8b" providerId="ADAL" clId="{045262AA-3CDD-44FA-8FDD-B4A21D74F4F7}" dt="2022-03-02T10:55:49.850" v="55" actId="165"/>
          <ac:picMkLst>
            <pc:docMk/>
            <pc:sldMk cId="3513509246" sldId="256"/>
            <ac:picMk id="3" creationId="{2748FDED-478B-4CD4-B3DF-3EB6DA924E4F}"/>
          </ac:picMkLst>
        </pc:picChg>
        <pc:picChg chg="add mod modCrop">
          <ac:chgData name="CAMILA OSPINA AYALA" userId="78f2fe8b-a352-4d21-8a73-8c582c191c8b" providerId="ADAL" clId="{045262AA-3CDD-44FA-8FDD-B4A21D74F4F7}" dt="2022-03-02T17:01:35.957" v="135" actId="164"/>
          <ac:picMkLst>
            <pc:docMk/>
            <pc:sldMk cId="3513509246" sldId="256"/>
            <ac:picMk id="5" creationId="{26FC2F33-9E2C-4E36-8DF3-56DB6477B79C}"/>
          </ac:picMkLst>
        </pc:picChg>
        <pc:picChg chg="del mod">
          <ac:chgData name="CAMILA OSPINA AYALA" userId="78f2fe8b-a352-4d21-8a73-8c582c191c8b" providerId="ADAL" clId="{045262AA-3CDD-44FA-8FDD-B4A21D74F4F7}" dt="2022-03-02T10:49:58.917" v="1" actId="478"/>
          <ac:picMkLst>
            <pc:docMk/>
            <pc:sldMk cId="3513509246" sldId="256"/>
            <ac:picMk id="7" creationId="{87477C72-F0F7-4B37-A057-6FF4500B3AC3}"/>
          </ac:picMkLst>
        </pc:picChg>
        <pc:picChg chg="add mod modCrop">
          <ac:chgData name="CAMILA OSPINA AYALA" userId="78f2fe8b-a352-4d21-8a73-8c582c191c8b" providerId="ADAL" clId="{045262AA-3CDD-44FA-8FDD-B4A21D74F4F7}" dt="2022-03-02T17:01:55.796" v="139" actId="732"/>
          <ac:picMkLst>
            <pc:docMk/>
            <pc:sldMk cId="3513509246" sldId="256"/>
            <ac:picMk id="7" creationId="{BD6FC14D-4229-4E51-AF11-1EFC94B3D640}"/>
          </ac:picMkLst>
        </pc:picChg>
        <pc:picChg chg="mod">
          <ac:chgData name="CAMILA OSPINA AYALA" userId="78f2fe8b-a352-4d21-8a73-8c582c191c8b" providerId="ADAL" clId="{045262AA-3CDD-44FA-8FDD-B4A21D74F4F7}" dt="2022-03-02T10:55:49.850" v="55" actId="165"/>
          <ac:picMkLst>
            <pc:docMk/>
            <pc:sldMk cId="3513509246" sldId="256"/>
            <ac:picMk id="18" creationId="{5E2E3BE4-D8DF-45CE-80E8-69E01C751179}"/>
          </ac:picMkLst>
        </pc:picChg>
        <pc:picChg chg="mod">
          <ac:chgData name="CAMILA OSPINA AYALA" userId="78f2fe8b-a352-4d21-8a73-8c582c191c8b" providerId="ADAL" clId="{045262AA-3CDD-44FA-8FDD-B4A21D74F4F7}" dt="2022-03-02T10:55:49.850" v="55" actId="165"/>
          <ac:picMkLst>
            <pc:docMk/>
            <pc:sldMk cId="3513509246" sldId="256"/>
            <ac:picMk id="20" creationId="{D2B966CF-BD00-4476-8C77-EE159EC54D2D}"/>
          </ac:picMkLst>
        </pc:picChg>
        <pc:picChg chg="mod">
          <ac:chgData name="CAMILA OSPINA AYALA" userId="78f2fe8b-a352-4d21-8a73-8c582c191c8b" providerId="ADAL" clId="{045262AA-3CDD-44FA-8FDD-B4A21D74F4F7}" dt="2022-03-02T10:55:49.850" v="55" actId="165"/>
          <ac:picMkLst>
            <pc:docMk/>
            <pc:sldMk cId="3513509246" sldId="256"/>
            <ac:picMk id="22" creationId="{36557F51-4591-406D-A74B-AA0F86974730}"/>
          </ac:picMkLst>
        </pc:picChg>
        <pc:picChg chg="mod">
          <ac:chgData name="CAMILA OSPINA AYALA" userId="78f2fe8b-a352-4d21-8a73-8c582c191c8b" providerId="ADAL" clId="{045262AA-3CDD-44FA-8FDD-B4A21D74F4F7}" dt="2022-03-02T10:55:49.850" v="55" actId="165"/>
          <ac:picMkLst>
            <pc:docMk/>
            <pc:sldMk cId="3513509246" sldId="256"/>
            <ac:picMk id="24" creationId="{53327AEA-8B5E-4FB8-94DB-CA62964753AB}"/>
          </ac:picMkLst>
        </pc:picChg>
        <pc:picChg chg="add del mod topLvl modCrop">
          <ac:chgData name="CAMILA OSPINA AYALA" userId="78f2fe8b-a352-4d21-8a73-8c582c191c8b" providerId="ADAL" clId="{045262AA-3CDD-44FA-8FDD-B4A21D74F4F7}" dt="2022-03-02T17:00:48.797" v="125" actId="478"/>
          <ac:picMkLst>
            <pc:docMk/>
            <pc:sldMk cId="3513509246" sldId="256"/>
            <ac:picMk id="36" creationId="{240CFFA7-6776-4BB4-A10E-110E4608601C}"/>
          </ac:picMkLst>
        </pc:picChg>
        <pc:picChg chg="add del mod ord topLvl modCrop">
          <ac:chgData name="CAMILA OSPINA AYALA" userId="78f2fe8b-a352-4d21-8a73-8c582c191c8b" providerId="ADAL" clId="{045262AA-3CDD-44FA-8FDD-B4A21D74F4F7}" dt="2022-03-02T16:50:54.047" v="81" actId="478"/>
          <ac:picMkLst>
            <pc:docMk/>
            <pc:sldMk cId="3513509246" sldId="256"/>
            <ac:picMk id="37" creationId="{5E6B721C-733D-4DDF-BFB0-4D1DDB586641}"/>
          </ac:picMkLst>
        </pc:picChg>
        <pc:picChg chg="add del mod">
          <ac:chgData name="CAMILA OSPINA AYALA" userId="78f2fe8b-a352-4d21-8a73-8c582c191c8b" providerId="ADAL" clId="{045262AA-3CDD-44FA-8FDD-B4A21D74F4F7}" dt="2022-03-02T10:56:38.460" v="66"/>
          <ac:picMkLst>
            <pc:docMk/>
            <pc:sldMk cId="3513509246" sldId="256"/>
            <ac:picMk id="38" creationId="{439D82FD-8D7E-4AFD-971F-1AFCCD8BEE78}"/>
          </ac:picMkLst>
        </pc:picChg>
        <pc:picChg chg="mod">
          <ac:chgData name="CAMILA OSPINA AYALA" userId="78f2fe8b-a352-4d21-8a73-8c582c191c8b" providerId="ADAL" clId="{045262AA-3CDD-44FA-8FDD-B4A21D74F4F7}" dt="2022-03-02T16:40:17.640" v="78"/>
          <ac:picMkLst>
            <pc:docMk/>
            <pc:sldMk cId="3513509246" sldId="256"/>
            <ac:picMk id="39" creationId="{B8026C4D-E96E-475B-8DFD-AA753E737CE1}"/>
          </ac:picMkLst>
        </pc:picChg>
        <pc:picChg chg="mod">
          <ac:chgData name="CAMILA OSPINA AYALA" userId="78f2fe8b-a352-4d21-8a73-8c582c191c8b" providerId="ADAL" clId="{045262AA-3CDD-44FA-8FDD-B4A21D74F4F7}" dt="2022-03-02T16:40:17.640" v="78"/>
          <ac:picMkLst>
            <pc:docMk/>
            <pc:sldMk cId="3513509246" sldId="256"/>
            <ac:picMk id="40" creationId="{D2A35DA9-3002-42E6-A8E1-37C2A0E0760E}"/>
          </ac:picMkLst>
        </pc:picChg>
        <pc:picChg chg="mod">
          <ac:chgData name="CAMILA OSPINA AYALA" userId="78f2fe8b-a352-4d21-8a73-8c582c191c8b" providerId="ADAL" clId="{045262AA-3CDD-44FA-8FDD-B4A21D74F4F7}" dt="2022-03-02T16:53:59.567" v="121"/>
          <ac:picMkLst>
            <pc:docMk/>
            <pc:sldMk cId="3513509246" sldId="256"/>
            <ac:picMk id="52" creationId="{1EC6DC8F-D718-4DDF-B823-B5CEC5E01821}"/>
          </ac:picMkLst>
        </pc:picChg>
        <pc:picChg chg="mod">
          <ac:chgData name="CAMILA OSPINA AYALA" userId="78f2fe8b-a352-4d21-8a73-8c582c191c8b" providerId="ADAL" clId="{045262AA-3CDD-44FA-8FDD-B4A21D74F4F7}" dt="2022-03-02T16:53:59.567" v="121"/>
          <ac:picMkLst>
            <pc:docMk/>
            <pc:sldMk cId="3513509246" sldId="256"/>
            <ac:picMk id="54" creationId="{C97BD713-44B9-4493-9E5C-12DE47CE28DD}"/>
          </ac:picMkLst>
        </pc:picChg>
        <pc:picChg chg="mod">
          <ac:chgData name="CAMILA OSPINA AYALA" userId="78f2fe8b-a352-4d21-8a73-8c582c191c8b" providerId="ADAL" clId="{045262AA-3CDD-44FA-8FDD-B4A21D74F4F7}" dt="2022-03-02T16:53:59.567" v="121"/>
          <ac:picMkLst>
            <pc:docMk/>
            <pc:sldMk cId="3513509246" sldId="256"/>
            <ac:picMk id="55" creationId="{38818E8B-7D2A-4B55-98FF-EA8ACDA25348}"/>
          </ac:picMkLst>
        </pc:picChg>
        <pc:picChg chg="mod">
          <ac:chgData name="CAMILA OSPINA AYALA" userId="78f2fe8b-a352-4d21-8a73-8c582c191c8b" providerId="ADAL" clId="{045262AA-3CDD-44FA-8FDD-B4A21D74F4F7}" dt="2022-03-02T16:53:59.567" v="121"/>
          <ac:picMkLst>
            <pc:docMk/>
            <pc:sldMk cId="3513509246" sldId="256"/>
            <ac:picMk id="56" creationId="{55C1F10F-1D5F-4967-99D1-E0A0A9239441}"/>
          </ac:picMkLst>
        </pc:picChg>
        <pc:picChg chg="mod">
          <ac:chgData name="CAMILA OSPINA AYALA" userId="78f2fe8b-a352-4d21-8a73-8c582c191c8b" providerId="ADAL" clId="{045262AA-3CDD-44FA-8FDD-B4A21D74F4F7}" dt="2022-03-02T16:53:59.567" v="121"/>
          <ac:picMkLst>
            <pc:docMk/>
            <pc:sldMk cId="3513509246" sldId="256"/>
            <ac:picMk id="61" creationId="{B613C266-33C5-425A-8568-775EDE33BE16}"/>
          </ac:picMkLst>
        </pc:picChg>
      </pc:sldChg>
    </pc:docChg>
  </pc:docChgLst>
  <pc:docChgLst>
    <pc:chgData name="CAMILA OSPINA AYALA" userId="78f2fe8b-a352-4d21-8a73-8c582c191c8b" providerId="ADAL" clId="{AB7D9840-CA5B-4FFC-A813-372B7C481899}"/>
    <pc:docChg chg="undo custSel modSld">
      <pc:chgData name="CAMILA OSPINA AYALA" userId="78f2fe8b-a352-4d21-8a73-8c582c191c8b" providerId="ADAL" clId="{AB7D9840-CA5B-4FFC-A813-372B7C481899}" dt="2021-11-09T13:47:23.937" v="78" actId="14100"/>
      <pc:docMkLst>
        <pc:docMk/>
      </pc:docMkLst>
      <pc:sldChg chg="addSp delSp modSp">
        <pc:chgData name="CAMILA OSPINA AYALA" userId="78f2fe8b-a352-4d21-8a73-8c582c191c8b" providerId="ADAL" clId="{AB7D9840-CA5B-4FFC-A813-372B7C481899}" dt="2021-11-09T13:47:23.937" v="78" actId="14100"/>
        <pc:sldMkLst>
          <pc:docMk/>
          <pc:sldMk cId="3513509246" sldId="256"/>
        </pc:sldMkLst>
        <pc:spChg chg="add mod">
          <ac:chgData name="CAMILA OSPINA AYALA" userId="78f2fe8b-a352-4d21-8a73-8c582c191c8b" providerId="ADAL" clId="{AB7D9840-CA5B-4FFC-A813-372B7C481899}" dt="2021-11-09T13:44:37.049" v="68" actId="164"/>
          <ac:spMkLst>
            <pc:docMk/>
            <pc:sldMk cId="3513509246" sldId="256"/>
            <ac:spMk id="14" creationId="{559545BB-4BA5-4679-B338-FBC782E75B16}"/>
          </ac:spMkLst>
        </pc:spChg>
        <pc:spChg chg="mod topLvl">
          <ac:chgData name="CAMILA OSPINA AYALA" userId="78f2fe8b-a352-4d21-8a73-8c582c191c8b" providerId="ADAL" clId="{AB7D9840-CA5B-4FFC-A813-372B7C481899}" dt="2021-11-09T13:44:37.049" v="68" actId="164"/>
          <ac:spMkLst>
            <pc:docMk/>
            <pc:sldMk cId="3513509246" sldId="256"/>
            <ac:spMk id="30" creationId="{F3C4E3DD-1D10-4D5A-81CD-763ECE650A65}"/>
          </ac:spMkLst>
        </pc:spChg>
        <pc:spChg chg="mod topLvl">
          <ac:chgData name="CAMILA OSPINA AYALA" userId="78f2fe8b-a352-4d21-8a73-8c582c191c8b" providerId="ADAL" clId="{AB7D9840-CA5B-4FFC-A813-372B7C481899}" dt="2021-11-09T13:44:37.049" v="68" actId="164"/>
          <ac:spMkLst>
            <pc:docMk/>
            <pc:sldMk cId="3513509246" sldId="256"/>
            <ac:spMk id="31" creationId="{07AE9398-1881-469F-951D-29ADA2B178B6}"/>
          </ac:spMkLst>
        </pc:spChg>
        <pc:spChg chg="mod topLvl">
          <ac:chgData name="CAMILA OSPINA AYALA" userId="78f2fe8b-a352-4d21-8a73-8c582c191c8b" providerId="ADAL" clId="{AB7D9840-CA5B-4FFC-A813-372B7C481899}" dt="2021-11-09T13:44:37.049" v="68" actId="164"/>
          <ac:spMkLst>
            <pc:docMk/>
            <pc:sldMk cId="3513509246" sldId="256"/>
            <ac:spMk id="32" creationId="{F663FA82-1B76-4B5E-939C-AED05F0BEF2C}"/>
          </ac:spMkLst>
        </pc:spChg>
        <pc:spChg chg="mod topLvl">
          <ac:chgData name="CAMILA OSPINA AYALA" userId="78f2fe8b-a352-4d21-8a73-8c582c191c8b" providerId="ADAL" clId="{AB7D9840-CA5B-4FFC-A813-372B7C481899}" dt="2021-11-09T13:44:37.049" v="68" actId="164"/>
          <ac:spMkLst>
            <pc:docMk/>
            <pc:sldMk cId="3513509246" sldId="256"/>
            <ac:spMk id="33" creationId="{44C6A6F1-68BE-4290-B0AA-CE94068E701A}"/>
          </ac:spMkLst>
        </pc:spChg>
        <pc:grpChg chg="del">
          <ac:chgData name="CAMILA OSPINA AYALA" userId="78f2fe8b-a352-4d21-8a73-8c582c191c8b" providerId="ADAL" clId="{AB7D9840-CA5B-4FFC-A813-372B7C481899}" dt="2021-11-09T13:40:49.942" v="9" actId="165"/>
          <ac:grpSpMkLst>
            <pc:docMk/>
            <pc:sldMk cId="3513509246" sldId="256"/>
            <ac:grpSpMk id="4" creationId="{8765459E-59E5-41B9-B49C-6C3B9E76EF99}"/>
          </ac:grpSpMkLst>
        </pc:grpChg>
        <pc:grpChg chg="add mod ord">
          <ac:chgData name="CAMILA OSPINA AYALA" userId="78f2fe8b-a352-4d21-8a73-8c582c191c8b" providerId="ADAL" clId="{AB7D9840-CA5B-4FFC-A813-372B7C481899}" dt="2021-11-09T13:47:14.087" v="75" actId="164"/>
          <ac:grpSpMkLst>
            <pc:docMk/>
            <pc:sldMk cId="3513509246" sldId="256"/>
            <ac:grpSpMk id="15" creationId="{7E83C65F-6016-4224-B46D-4B3AC52081C9}"/>
          </ac:grpSpMkLst>
        </pc:grpChg>
        <pc:grpChg chg="add mod">
          <ac:chgData name="CAMILA OSPINA AYALA" userId="78f2fe8b-a352-4d21-8a73-8c582c191c8b" providerId="ADAL" clId="{AB7D9840-CA5B-4FFC-A813-372B7C481899}" dt="2021-11-09T13:47:14.087" v="75" actId="164"/>
          <ac:grpSpMkLst>
            <pc:docMk/>
            <pc:sldMk cId="3513509246" sldId="256"/>
            <ac:grpSpMk id="16" creationId="{5BD62117-51CC-49FD-9B14-D0BD3D7E5606}"/>
          </ac:grpSpMkLst>
        </pc:grpChg>
        <pc:picChg chg="add mod modCrop">
          <ac:chgData name="CAMILA OSPINA AYALA" userId="78f2fe8b-a352-4d21-8a73-8c582c191c8b" providerId="ADAL" clId="{AB7D9840-CA5B-4FFC-A813-372B7C481899}" dt="2021-11-09T13:44:37.049" v="68" actId="164"/>
          <ac:picMkLst>
            <pc:docMk/>
            <pc:sldMk cId="3513509246" sldId="256"/>
            <ac:picMk id="3" creationId="{2748FDED-478B-4CD4-B3DF-3EB6DA924E4F}"/>
          </ac:picMkLst>
        </pc:picChg>
        <pc:picChg chg="del mod">
          <ac:chgData name="CAMILA OSPINA AYALA" userId="78f2fe8b-a352-4d21-8a73-8c582c191c8b" providerId="ADAL" clId="{AB7D9840-CA5B-4FFC-A813-372B7C481899}" dt="2021-11-09T13:41:50.045" v="42" actId="478"/>
          <ac:picMkLst>
            <pc:docMk/>
            <pc:sldMk cId="3513509246" sldId="256"/>
            <ac:picMk id="5" creationId="{6CF85439-18F4-496C-B123-F523870D85F2}"/>
          </ac:picMkLst>
        </pc:picChg>
        <pc:picChg chg="add del mod">
          <ac:chgData name="CAMILA OSPINA AYALA" userId="78f2fe8b-a352-4d21-8a73-8c582c191c8b" providerId="ADAL" clId="{AB7D9840-CA5B-4FFC-A813-372B7C481899}" dt="2021-11-09T13:42:08.734" v="44" actId="478"/>
          <ac:picMkLst>
            <pc:docMk/>
            <pc:sldMk cId="3513509246" sldId="256"/>
            <ac:picMk id="7" creationId="{BD85E238-25E4-4118-9D82-95D7D004AFBD}"/>
          </ac:picMkLst>
        </pc:picChg>
        <pc:picChg chg="add del mod">
          <ac:chgData name="CAMILA OSPINA AYALA" userId="78f2fe8b-a352-4d21-8a73-8c582c191c8b" providerId="ADAL" clId="{AB7D9840-CA5B-4FFC-A813-372B7C481899}" dt="2021-11-09T13:42:31.880" v="47" actId="478"/>
          <ac:picMkLst>
            <pc:docMk/>
            <pc:sldMk cId="3513509246" sldId="256"/>
            <ac:picMk id="9" creationId="{D8BD357C-3D06-4ECE-809D-6CEC56736D79}"/>
          </ac:picMkLst>
        </pc:picChg>
        <pc:picChg chg="add del mod">
          <ac:chgData name="CAMILA OSPINA AYALA" userId="78f2fe8b-a352-4d21-8a73-8c582c191c8b" providerId="ADAL" clId="{AB7D9840-CA5B-4FFC-A813-372B7C481899}" dt="2021-11-09T13:42:57" v="50" actId="478"/>
          <ac:picMkLst>
            <pc:docMk/>
            <pc:sldMk cId="3513509246" sldId="256"/>
            <ac:picMk id="11" creationId="{C95944BA-BEA0-444F-869D-085F7F6C5139}"/>
          </ac:picMkLst>
        </pc:picChg>
        <pc:picChg chg="add mod modCrop">
          <ac:chgData name="CAMILA OSPINA AYALA" userId="78f2fe8b-a352-4d21-8a73-8c582c191c8b" providerId="ADAL" clId="{AB7D9840-CA5B-4FFC-A813-372B7C481899}" dt="2021-11-09T13:47:23.937" v="78" actId="14100"/>
          <ac:picMkLst>
            <pc:docMk/>
            <pc:sldMk cId="3513509246" sldId="256"/>
            <ac:picMk id="13" creationId="{3528E06E-326A-4332-977C-BC054873EE2B}"/>
          </ac:picMkLst>
        </pc:picChg>
        <pc:picChg chg="mod topLvl">
          <ac:chgData name="CAMILA OSPINA AYALA" userId="78f2fe8b-a352-4d21-8a73-8c582c191c8b" providerId="ADAL" clId="{AB7D9840-CA5B-4FFC-A813-372B7C481899}" dt="2021-11-09T13:44:37.049" v="68" actId="164"/>
          <ac:picMkLst>
            <pc:docMk/>
            <pc:sldMk cId="3513509246" sldId="256"/>
            <ac:picMk id="18" creationId="{5E2E3BE4-D8DF-45CE-80E8-69E01C751179}"/>
          </ac:picMkLst>
        </pc:picChg>
        <pc:picChg chg="mod topLvl">
          <ac:chgData name="CAMILA OSPINA AYALA" userId="78f2fe8b-a352-4d21-8a73-8c582c191c8b" providerId="ADAL" clId="{AB7D9840-CA5B-4FFC-A813-372B7C481899}" dt="2021-11-09T13:47:14.087" v="75" actId="164"/>
          <ac:picMkLst>
            <pc:docMk/>
            <pc:sldMk cId="3513509246" sldId="256"/>
            <ac:picMk id="20" creationId="{D2B966CF-BD00-4476-8C77-EE159EC54D2D}"/>
          </ac:picMkLst>
        </pc:picChg>
        <pc:picChg chg="mod topLvl">
          <ac:chgData name="CAMILA OSPINA AYALA" userId="78f2fe8b-a352-4d21-8a73-8c582c191c8b" providerId="ADAL" clId="{AB7D9840-CA5B-4FFC-A813-372B7C481899}" dt="2021-11-09T13:44:37.049" v="68" actId="164"/>
          <ac:picMkLst>
            <pc:docMk/>
            <pc:sldMk cId="3513509246" sldId="256"/>
            <ac:picMk id="22" creationId="{36557F51-4591-406D-A74B-AA0F86974730}"/>
          </ac:picMkLst>
        </pc:picChg>
        <pc:picChg chg="mod topLvl">
          <ac:chgData name="CAMILA OSPINA AYALA" userId="78f2fe8b-a352-4d21-8a73-8c582c191c8b" providerId="ADAL" clId="{AB7D9840-CA5B-4FFC-A813-372B7C481899}" dt="2021-11-09T13:44:37.049" v="68" actId="164"/>
          <ac:picMkLst>
            <pc:docMk/>
            <pc:sldMk cId="3513509246" sldId="256"/>
            <ac:picMk id="24" creationId="{53327AEA-8B5E-4FB8-94DB-CA62964753AB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E441A61-7D5C-4C1E-98C6-A7A05559FB6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5C893DF5-944C-4E2F-A0D4-433B9C9AA9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F4B69738-C9FF-4A89-8EB5-DBC3DE97BF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2716A829-1469-4926-951D-D150FD12DA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F0E1E362-0F51-4FED-8503-4C04FE575F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702812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4798890-C06A-41C7-A3BE-289EE56207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2D998D7E-2AAF-455E-8EB4-3521F9D162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2FBB33E8-8A0F-4070-84CC-CBDB4ECAB3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62D9E2C-8F7C-4F95-B296-AFFDC6DFD7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14EB4553-B907-42B7-A342-DE03F09AA3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944342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632D1814-E652-4763-959B-5B3D0076D94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FA87DACC-56C5-43D2-A8CB-659FEE9DC4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E1154AC2-BB19-42A6-A5D0-B4B1F5E98E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2955D94-8EC9-4B05-8ED6-49284BC640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E93F76BC-BD1D-4447-A01A-EB14F7C04A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301740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57B74B9-1236-4EF6-A2AD-FBD77A29E4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A55FFCA8-39E7-4850-8B00-4103A9F266D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3724F01F-4C4D-46EB-BDB2-704D45F6A2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761BD0A-4F59-49F2-8D26-159445E532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1B46113C-A1F6-4A75-A594-3BE8145DD0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698807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92F70D6-8B5D-4ED4-8971-699B0D180A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DA89B727-33B6-4EBF-8A8C-A068D02DEC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1D854AAE-044C-4F7B-B179-122D28F196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3FEF864D-E39B-4EBA-ADB0-6FC8F80A2E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EF7245A7-27CB-404F-9114-9EA9455E8C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884448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50C124E-355C-4F2B-A267-D714738085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9ACBD224-AE35-49C8-8091-A0DF82B4BAA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02476E06-9702-4449-9D7F-4D5B2C4DAA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E97BEE62-1B25-492C-B3C9-784CB73463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03D264FB-A64C-4422-98CF-5D52F9513B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1BBD16AB-150D-49AD-A643-4719D0178B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515701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6FFFD2D-D51C-4B14-807E-BD69DF11E8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0718BFB2-3770-4AC7-82C4-C1DCD88A10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E93814FB-E5C9-497C-9CB4-8BF6554C99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B96023B8-36E6-4CB5-9E41-F16635B1287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986AFEA6-F7EE-40D3-8374-DC3E161389B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F73CD24C-BEEF-42DF-83F5-69BBF5C111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45B80B3A-789E-49A0-B0EB-4E8E1AF04B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87457ED8-3AE6-4C6C-88F6-4EFA868329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328921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3098184-B0F1-4D9D-94E5-A5719A4E67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AC6DA878-F54E-449C-A4BB-B82806916E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81B821EC-A481-4E3C-A71B-D045345CDD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0F8B1289-AE6D-4409-B6BD-158A578313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6922751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23C05A06-C5BF-422A-B960-D0F65EE409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D5CD1DDB-EA0F-469A-B906-80B9969CEB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851136C3-2EB9-4C4B-88C4-8903884DCF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748618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9051EE3-341C-4883-8F06-C319E12C3A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1AA2537E-3EC1-46E4-8FF1-55E94EA5A6E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D122A7DD-400B-4314-8235-2AEACD68E6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3B8DD15D-B411-438F-8E50-106643F964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4304E1C5-DAC9-4E86-9847-4DD3704026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91B275FA-A957-4003-99F7-D2E08B1BC9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499798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0D118D9-8C35-4ED7-BD2F-77DE5FD748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9683050A-ABAB-475B-98D3-F8B43F1A7A3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B9D132FE-13F8-42D5-BCD8-9075CBD790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2EB35309-1F4F-4D7F-B416-65F9F73771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88C6CB88-8BC5-4F7E-81CF-3DE646631A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2323CD44-AC7A-4A16-9622-EB8385E812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2546746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01E297AD-1012-46EC-B217-7008C3B0F0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CAE9DCFF-2DF6-4C37-AE01-935A5D362B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2665C307-17D7-40CA-B656-ADC9854D13F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B62F454B-1DAC-4C5F-A0CE-CD5D2B1DBDC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E141D767-ADE0-4ED5-ABEB-74D5AD587C0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719380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mp"/><Relationship Id="rId3" Type="http://schemas.openxmlformats.org/officeDocument/2006/relationships/image" Target="../media/image2.tmp"/><Relationship Id="rId7" Type="http://schemas.openxmlformats.org/officeDocument/2006/relationships/image" Target="../media/image6.tmp"/><Relationship Id="rId2" Type="http://schemas.openxmlformats.org/officeDocument/2006/relationships/image" Target="../media/image1.tmp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mp"/><Relationship Id="rId5" Type="http://schemas.openxmlformats.org/officeDocument/2006/relationships/image" Target="../media/image4.tmp"/><Relationship Id="rId4" Type="http://schemas.openxmlformats.org/officeDocument/2006/relationships/image" Target="../media/image3.tm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Agrupar 1">
            <a:extLst>
              <a:ext uri="{FF2B5EF4-FFF2-40B4-BE49-F238E27FC236}">
                <a16:creationId xmlns:a16="http://schemas.microsoft.com/office/drawing/2014/main" id="{6927146B-06B4-41B4-AD3D-AA0F2FB64A1B}"/>
              </a:ext>
            </a:extLst>
          </p:cNvPr>
          <p:cNvGrpSpPr/>
          <p:nvPr/>
        </p:nvGrpSpPr>
        <p:grpSpPr>
          <a:xfrm>
            <a:off x="412633" y="536712"/>
            <a:ext cx="1288051" cy="5210379"/>
            <a:chOff x="237221" y="365796"/>
            <a:chExt cx="2090330" cy="5637138"/>
          </a:xfrm>
        </p:grpSpPr>
        <p:sp>
          <p:nvSpPr>
            <p:cNvPr id="19" name="CaixaDeTexto 18">
              <a:extLst>
                <a:ext uri="{FF2B5EF4-FFF2-40B4-BE49-F238E27FC236}">
                  <a16:creationId xmlns:a16="http://schemas.microsoft.com/office/drawing/2014/main" id="{AC4C3DC5-C950-4469-B152-4E43DE1B5036}"/>
                </a:ext>
              </a:extLst>
            </p:cNvPr>
            <p:cNvSpPr txBox="1"/>
            <p:nvPr/>
          </p:nvSpPr>
          <p:spPr>
            <a:xfrm>
              <a:off x="372664" y="365796"/>
              <a:ext cx="1887165" cy="4380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Translation process</a:t>
              </a:r>
              <a:endParaRPr lang="pt-BR" sz="12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1" name="CaixaDeTexto 20">
              <a:extLst>
                <a:ext uri="{FF2B5EF4-FFF2-40B4-BE49-F238E27FC236}">
                  <a16:creationId xmlns:a16="http://schemas.microsoft.com/office/drawing/2014/main" id="{1CA3E8AA-CACE-4939-89EE-2E2C569FA7D2}"/>
                </a:ext>
              </a:extLst>
            </p:cNvPr>
            <p:cNvSpPr txBox="1"/>
            <p:nvPr/>
          </p:nvSpPr>
          <p:spPr>
            <a:xfrm>
              <a:off x="372664" y="1012347"/>
              <a:ext cx="1887165" cy="2628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ontent validity </a:t>
              </a:r>
              <a:endParaRPr lang="pt-BR" sz="12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3" name="CaixaDeTexto 22">
              <a:extLst>
                <a:ext uri="{FF2B5EF4-FFF2-40B4-BE49-F238E27FC236}">
                  <a16:creationId xmlns:a16="http://schemas.microsoft.com/office/drawing/2014/main" id="{2223FC15-4D9E-4B6E-8A58-F6F5B19D2659}"/>
                </a:ext>
              </a:extLst>
            </p:cNvPr>
            <p:cNvSpPr txBox="1"/>
            <p:nvPr/>
          </p:nvSpPr>
          <p:spPr>
            <a:xfrm>
              <a:off x="372664" y="1536556"/>
              <a:ext cx="1887164" cy="4380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ypotheses testing </a:t>
              </a:r>
              <a:endParaRPr lang="pt-BR" sz="12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5" name="CaixaDeTexto 24">
              <a:extLst>
                <a:ext uri="{FF2B5EF4-FFF2-40B4-BE49-F238E27FC236}">
                  <a16:creationId xmlns:a16="http://schemas.microsoft.com/office/drawing/2014/main" id="{599088B4-5A7A-4909-B659-A569413595EE}"/>
                </a:ext>
              </a:extLst>
            </p:cNvPr>
            <p:cNvSpPr txBox="1"/>
            <p:nvPr/>
          </p:nvSpPr>
          <p:spPr>
            <a:xfrm>
              <a:off x="372664" y="2141238"/>
              <a:ext cx="1887165" cy="2628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Structural validity </a:t>
              </a:r>
              <a:endParaRPr lang="pt-BR" sz="12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6" name="CaixaDeTexto 25">
              <a:extLst>
                <a:ext uri="{FF2B5EF4-FFF2-40B4-BE49-F238E27FC236}">
                  <a16:creationId xmlns:a16="http://schemas.microsoft.com/office/drawing/2014/main" id="{000E1D5E-750D-4A86-887D-B8AE804C8B3B}"/>
                </a:ext>
              </a:extLst>
            </p:cNvPr>
            <p:cNvSpPr txBox="1"/>
            <p:nvPr/>
          </p:nvSpPr>
          <p:spPr>
            <a:xfrm>
              <a:off x="314665" y="2839851"/>
              <a:ext cx="1887164" cy="2628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riterion validity </a:t>
              </a:r>
              <a:endParaRPr lang="pt-BR" sz="12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7" name="CaixaDeTexto 26">
              <a:extLst>
                <a:ext uri="{FF2B5EF4-FFF2-40B4-BE49-F238E27FC236}">
                  <a16:creationId xmlns:a16="http://schemas.microsoft.com/office/drawing/2014/main" id="{EDE3F7CC-9264-4DB8-90A9-8EF5F9D9F236}"/>
                </a:ext>
              </a:extLst>
            </p:cNvPr>
            <p:cNvSpPr txBox="1"/>
            <p:nvPr/>
          </p:nvSpPr>
          <p:spPr>
            <a:xfrm>
              <a:off x="372664" y="3400730"/>
              <a:ext cx="1887165" cy="4380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Internal consistency </a:t>
              </a:r>
              <a:endParaRPr lang="pt-BR" sz="12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8" name="CaixaDeTexto 27">
              <a:extLst>
                <a:ext uri="{FF2B5EF4-FFF2-40B4-BE49-F238E27FC236}">
                  <a16:creationId xmlns:a16="http://schemas.microsoft.com/office/drawing/2014/main" id="{4932058E-A20F-4F48-953C-EDBFFCE96125}"/>
                </a:ext>
              </a:extLst>
            </p:cNvPr>
            <p:cNvSpPr txBox="1"/>
            <p:nvPr/>
          </p:nvSpPr>
          <p:spPr>
            <a:xfrm>
              <a:off x="372664" y="4017149"/>
              <a:ext cx="1887165" cy="4380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Reliability Test-retest</a:t>
              </a:r>
              <a:endParaRPr lang="pt-BR" sz="12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9" name="CaixaDeTexto 28">
              <a:extLst>
                <a:ext uri="{FF2B5EF4-FFF2-40B4-BE49-F238E27FC236}">
                  <a16:creationId xmlns:a16="http://schemas.microsoft.com/office/drawing/2014/main" id="{5751DFF6-0BE3-49DA-9152-418AC0EC2206}"/>
                </a:ext>
              </a:extLst>
            </p:cNvPr>
            <p:cNvSpPr txBox="1"/>
            <p:nvPr/>
          </p:nvSpPr>
          <p:spPr>
            <a:xfrm>
              <a:off x="304941" y="4616059"/>
              <a:ext cx="2022610" cy="4380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Measurement invariance </a:t>
              </a:r>
              <a:endParaRPr lang="pt-BR" sz="12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4" name="CaixaDeTexto 33">
              <a:extLst>
                <a:ext uri="{FF2B5EF4-FFF2-40B4-BE49-F238E27FC236}">
                  <a16:creationId xmlns:a16="http://schemas.microsoft.com/office/drawing/2014/main" id="{0CE25098-89F7-4813-B544-78663C75256E}"/>
                </a:ext>
              </a:extLst>
            </p:cNvPr>
            <p:cNvSpPr txBox="1"/>
            <p:nvPr/>
          </p:nvSpPr>
          <p:spPr>
            <a:xfrm>
              <a:off x="237221" y="5220742"/>
              <a:ext cx="2022608" cy="3093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Responsiveness</a:t>
              </a:r>
              <a:endParaRPr lang="pt-BR" sz="12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5" name="CaixaDeTexto 34">
              <a:extLst>
                <a:ext uri="{FF2B5EF4-FFF2-40B4-BE49-F238E27FC236}">
                  <a16:creationId xmlns:a16="http://schemas.microsoft.com/office/drawing/2014/main" id="{2843D0DD-7137-4E59-8F50-E9A10B68152C}"/>
                </a:ext>
              </a:extLst>
            </p:cNvPr>
            <p:cNvSpPr txBox="1"/>
            <p:nvPr/>
          </p:nvSpPr>
          <p:spPr>
            <a:xfrm>
              <a:off x="372664" y="5740119"/>
              <a:ext cx="1887165" cy="2628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Overall</a:t>
              </a:r>
              <a:endParaRPr lang="pt-BR" sz="12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8" name="Agrupar 7">
            <a:extLst>
              <a:ext uri="{FF2B5EF4-FFF2-40B4-BE49-F238E27FC236}">
                <a16:creationId xmlns:a16="http://schemas.microsoft.com/office/drawing/2014/main" id="{D817D991-9593-4D73-8A00-9379779F553F}"/>
              </a:ext>
            </a:extLst>
          </p:cNvPr>
          <p:cNvGrpSpPr/>
          <p:nvPr/>
        </p:nvGrpSpPr>
        <p:grpSpPr>
          <a:xfrm>
            <a:off x="6244524" y="583097"/>
            <a:ext cx="4586659" cy="5738190"/>
            <a:chOff x="6244524" y="703868"/>
            <a:chExt cx="4586659" cy="5507274"/>
          </a:xfrm>
        </p:grpSpPr>
        <p:pic>
          <p:nvPicPr>
            <p:cNvPr id="5" name="Imagem 4" descr="Gráfico, Gráfico de barras&#10;&#10;Descrição gerada automaticamente">
              <a:extLst>
                <a:ext uri="{FF2B5EF4-FFF2-40B4-BE49-F238E27FC236}">
                  <a16:creationId xmlns:a16="http://schemas.microsoft.com/office/drawing/2014/main" id="{26FC2F33-9E2C-4E36-8DF3-56DB6477B79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1032"/>
            <a:stretch/>
          </p:blipFill>
          <p:spPr>
            <a:xfrm>
              <a:off x="6244524" y="1747937"/>
              <a:ext cx="4586659" cy="4463205"/>
            </a:xfrm>
            <a:prstGeom prst="rect">
              <a:avLst/>
            </a:prstGeom>
          </p:spPr>
        </p:pic>
        <p:sp>
          <p:nvSpPr>
            <p:cNvPr id="43" name="Retângulo 42">
              <a:extLst>
                <a:ext uri="{FF2B5EF4-FFF2-40B4-BE49-F238E27FC236}">
                  <a16:creationId xmlns:a16="http://schemas.microsoft.com/office/drawing/2014/main" id="{E45EC198-C866-4132-8737-8E00EC3FB61B}"/>
                </a:ext>
              </a:extLst>
            </p:cNvPr>
            <p:cNvSpPr/>
            <p:nvPr/>
          </p:nvSpPr>
          <p:spPr>
            <a:xfrm>
              <a:off x="6374295" y="703868"/>
              <a:ext cx="4186542" cy="392204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  <a:ln w="19050">
              <a:solidFill>
                <a:schemeClr val="bg2">
                  <a:lumMod val="1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46" name="Retângulo 45">
              <a:extLst>
                <a:ext uri="{FF2B5EF4-FFF2-40B4-BE49-F238E27FC236}">
                  <a16:creationId xmlns:a16="http://schemas.microsoft.com/office/drawing/2014/main" id="{302F2040-E254-43B0-9DC5-4316B611DD09}"/>
                </a:ext>
              </a:extLst>
            </p:cNvPr>
            <p:cNvSpPr/>
            <p:nvPr/>
          </p:nvSpPr>
          <p:spPr>
            <a:xfrm>
              <a:off x="6374295" y="1200124"/>
              <a:ext cx="4186542" cy="392204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  <a:ln w="19050">
              <a:solidFill>
                <a:schemeClr val="bg2">
                  <a:lumMod val="1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47" name="Retângulo 46">
              <a:extLst>
                <a:ext uri="{FF2B5EF4-FFF2-40B4-BE49-F238E27FC236}">
                  <a16:creationId xmlns:a16="http://schemas.microsoft.com/office/drawing/2014/main" id="{5B996910-14B2-4F10-96FB-7F5F045FCD23}"/>
                </a:ext>
              </a:extLst>
            </p:cNvPr>
            <p:cNvSpPr/>
            <p:nvPr/>
          </p:nvSpPr>
          <p:spPr>
            <a:xfrm>
              <a:off x="7873704" y="5449430"/>
              <a:ext cx="806469" cy="360000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  <a:ln w="19050">
              <a:solidFill>
                <a:schemeClr val="bg2">
                  <a:lumMod val="1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</p:grpSp>
      <p:grpSp>
        <p:nvGrpSpPr>
          <p:cNvPr id="48" name="Agrupar 47">
            <a:extLst>
              <a:ext uri="{FF2B5EF4-FFF2-40B4-BE49-F238E27FC236}">
                <a16:creationId xmlns:a16="http://schemas.microsoft.com/office/drawing/2014/main" id="{AE8D2A32-11F0-447F-974B-D46D081BB987}"/>
              </a:ext>
            </a:extLst>
          </p:cNvPr>
          <p:cNvGrpSpPr/>
          <p:nvPr/>
        </p:nvGrpSpPr>
        <p:grpSpPr>
          <a:xfrm>
            <a:off x="10831183" y="2407025"/>
            <a:ext cx="1678869" cy="2389820"/>
            <a:chOff x="9774014" y="2473794"/>
            <a:chExt cx="2302081" cy="2389820"/>
          </a:xfrm>
        </p:grpSpPr>
        <p:grpSp>
          <p:nvGrpSpPr>
            <p:cNvPr id="49" name="Agrupar 48">
              <a:extLst>
                <a:ext uri="{FF2B5EF4-FFF2-40B4-BE49-F238E27FC236}">
                  <a16:creationId xmlns:a16="http://schemas.microsoft.com/office/drawing/2014/main" id="{EFB2301E-53EC-495F-8EC8-04A68FE9C76F}"/>
                </a:ext>
              </a:extLst>
            </p:cNvPr>
            <p:cNvGrpSpPr/>
            <p:nvPr/>
          </p:nvGrpSpPr>
          <p:grpSpPr>
            <a:xfrm>
              <a:off x="9774014" y="2473794"/>
              <a:ext cx="2302081" cy="1961213"/>
              <a:chOff x="9774014" y="2473794"/>
              <a:chExt cx="2302081" cy="1961213"/>
            </a:xfrm>
          </p:grpSpPr>
          <p:pic>
            <p:nvPicPr>
              <p:cNvPr id="52" name="Imagem 51">
                <a:extLst>
                  <a:ext uri="{FF2B5EF4-FFF2-40B4-BE49-F238E27FC236}">
                    <a16:creationId xmlns:a16="http://schemas.microsoft.com/office/drawing/2014/main" id="{1EC6DC8F-D718-4DDF-B823-B5CEC5E0182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775380" y="3452723"/>
                <a:ext cx="257211" cy="228632"/>
              </a:xfrm>
              <a:prstGeom prst="rect">
                <a:avLst/>
              </a:prstGeom>
            </p:spPr>
          </p:pic>
          <p:grpSp>
            <p:nvGrpSpPr>
              <p:cNvPr id="53" name="Agrupar 52">
                <a:extLst>
                  <a:ext uri="{FF2B5EF4-FFF2-40B4-BE49-F238E27FC236}">
                    <a16:creationId xmlns:a16="http://schemas.microsoft.com/office/drawing/2014/main" id="{5FD2E280-7A6B-4620-9AE8-07898E160FD0}"/>
                  </a:ext>
                </a:extLst>
              </p:cNvPr>
              <p:cNvGrpSpPr/>
              <p:nvPr/>
            </p:nvGrpSpPr>
            <p:grpSpPr>
              <a:xfrm>
                <a:off x="9774014" y="2473794"/>
                <a:ext cx="2302081" cy="1961213"/>
                <a:chOff x="9774014" y="2449321"/>
                <a:chExt cx="2302081" cy="1961213"/>
              </a:xfrm>
            </p:grpSpPr>
            <p:pic>
              <p:nvPicPr>
                <p:cNvPr id="54" name="Imagem 53">
                  <a:extLst>
                    <a:ext uri="{FF2B5EF4-FFF2-40B4-BE49-F238E27FC236}">
                      <a16:creationId xmlns:a16="http://schemas.microsoft.com/office/drawing/2014/main" id="{C97BD713-44B9-4493-9E5C-12DE47CE28D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789893" y="2970554"/>
                  <a:ext cx="228632" cy="257211"/>
                </a:xfrm>
                <a:prstGeom prst="rect">
                  <a:avLst/>
                </a:prstGeom>
              </p:spPr>
            </p:pic>
            <p:pic>
              <p:nvPicPr>
                <p:cNvPr id="55" name="Imagem 54">
                  <a:extLst>
                    <a:ext uri="{FF2B5EF4-FFF2-40B4-BE49-F238E27FC236}">
                      <a16:creationId xmlns:a16="http://schemas.microsoft.com/office/drawing/2014/main" id="{38818E8B-7D2A-4B55-98FF-EA8ACDA2534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774014" y="2469841"/>
                  <a:ext cx="257211" cy="266737"/>
                </a:xfrm>
                <a:prstGeom prst="rect">
                  <a:avLst/>
                </a:prstGeom>
              </p:spPr>
            </p:pic>
            <p:pic>
              <p:nvPicPr>
                <p:cNvPr id="56" name="Imagem 55">
                  <a:extLst>
                    <a:ext uri="{FF2B5EF4-FFF2-40B4-BE49-F238E27FC236}">
                      <a16:creationId xmlns:a16="http://schemas.microsoft.com/office/drawing/2014/main" id="{55C1F10F-1D5F-4967-99D1-E0A0A923944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799419" y="4163802"/>
                  <a:ext cx="238158" cy="228632"/>
                </a:xfrm>
                <a:prstGeom prst="rect">
                  <a:avLst/>
                </a:prstGeom>
              </p:spPr>
            </p:pic>
            <p:sp>
              <p:nvSpPr>
                <p:cNvPr id="57" name="CaixaDeTexto 56">
                  <a:extLst>
                    <a:ext uri="{FF2B5EF4-FFF2-40B4-BE49-F238E27FC236}">
                      <a16:creationId xmlns:a16="http://schemas.microsoft.com/office/drawing/2014/main" id="{BCCF56B5-13FF-44B8-92B7-0782234BB65A}"/>
                    </a:ext>
                  </a:extLst>
                </p:cNvPr>
                <p:cNvSpPr txBox="1"/>
                <p:nvPr/>
              </p:nvSpPr>
              <p:spPr>
                <a:xfrm>
                  <a:off x="10005825" y="2449321"/>
                  <a:ext cx="1887165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Very good</a:t>
                  </a:r>
                  <a:endParaRPr lang="pt-BR" sz="1400" b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58" name="CaixaDeTexto 57">
                  <a:extLst>
                    <a:ext uri="{FF2B5EF4-FFF2-40B4-BE49-F238E27FC236}">
                      <a16:creationId xmlns:a16="http://schemas.microsoft.com/office/drawing/2014/main" id="{F59E6A1B-6E37-40D0-B4A5-E1E745356E2F}"/>
                    </a:ext>
                  </a:extLst>
                </p:cNvPr>
                <p:cNvSpPr txBox="1"/>
                <p:nvPr/>
              </p:nvSpPr>
              <p:spPr>
                <a:xfrm>
                  <a:off x="10005824" y="2945271"/>
                  <a:ext cx="1887165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Adequate</a:t>
                  </a:r>
                  <a:endParaRPr lang="pt-BR" sz="1400" b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59" name="CaixaDeTexto 58">
                  <a:extLst>
                    <a:ext uri="{FF2B5EF4-FFF2-40B4-BE49-F238E27FC236}">
                      <a16:creationId xmlns:a16="http://schemas.microsoft.com/office/drawing/2014/main" id="{B7A647EC-8363-4802-B2B3-9A3E77547E8B}"/>
                    </a:ext>
                  </a:extLst>
                </p:cNvPr>
                <p:cNvSpPr txBox="1"/>
                <p:nvPr/>
              </p:nvSpPr>
              <p:spPr>
                <a:xfrm>
                  <a:off x="10018525" y="3413151"/>
                  <a:ext cx="1887165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Doubtful</a:t>
                  </a:r>
                  <a:endParaRPr lang="pt-BR" sz="1400" b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0" name="CaixaDeTexto 59">
                  <a:extLst>
                    <a:ext uri="{FF2B5EF4-FFF2-40B4-BE49-F238E27FC236}">
                      <a16:creationId xmlns:a16="http://schemas.microsoft.com/office/drawing/2014/main" id="{5C899AE7-7B7A-4281-B07B-901FF01D588E}"/>
                    </a:ext>
                  </a:extLst>
                </p:cNvPr>
                <p:cNvSpPr txBox="1"/>
                <p:nvPr/>
              </p:nvSpPr>
              <p:spPr>
                <a:xfrm>
                  <a:off x="10031225" y="4102757"/>
                  <a:ext cx="204487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Not reported</a:t>
                  </a:r>
                  <a:endParaRPr lang="pt-BR" sz="1400" b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pic>
              <p:nvPicPr>
                <p:cNvPr id="61" name="Imagem 60">
                  <a:extLst>
                    <a:ext uri="{FF2B5EF4-FFF2-40B4-BE49-F238E27FC236}">
                      <a16:creationId xmlns:a16="http://schemas.microsoft.com/office/drawing/2014/main" id="{B613C266-33C5-425A-8568-775EDE33BE1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6506" t="18695" r="38910" b="40626"/>
                <a:stretch/>
              </p:blipFill>
              <p:spPr>
                <a:xfrm>
                  <a:off x="9780366" y="3807602"/>
                  <a:ext cx="257211" cy="228632"/>
                </a:xfrm>
                <a:prstGeom prst="rect">
                  <a:avLst/>
                </a:prstGeom>
              </p:spPr>
            </p:pic>
            <p:sp>
              <p:nvSpPr>
                <p:cNvPr id="62" name="CaixaDeTexto 61">
                  <a:extLst>
                    <a:ext uri="{FF2B5EF4-FFF2-40B4-BE49-F238E27FC236}">
                      <a16:creationId xmlns:a16="http://schemas.microsoft.com/office/drawing/2014/main" id="{1CBA7B8D-42D1-4760-B704-6EF1D3205C29}"/>
                    </a:ext>
                  </a:extLst>
                </p:cNvPr>
                <p:cNvSpPr txBox="1"/>
                <p:nvPr/>
              </p:nvSpPr>
              <p:spPr>
                <a:xfrm>
                  <a:off x="10031225" y="3761718"/>
                  <a:ext cx="1887165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Inadequate</a:t>
                  </a:r>
                  <a:endParaRPr lang="pt-BR" sz="1400" b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</p:grpSp>
        </p:grpSp>
        <p:sp>
          <p:nvSpPr>
            <p:cNvPr id="50" name="Retângulo 49">
              <a:extLst>
                <a:ext uri="{FF2B5EF4-FFF2-40B4-BE49-F238E27FC236}">
                  <a16:creationId xmlns:a16="http://schemas.microsoft.com/office/drawing/2014/main" id="{095FBAFF-2BA5-4DC5-B43B-CCE10A115593}"/>
                </a:ext>
              </a:extLst>
            </p:cNvPr>
            <p:cNvSpPr/>
            <p:nvPr/>
          </p:nvSpPr>
          <p:spPr>
            <a:xfrm>
              <a:off x="9799419" y="4583362"/>
              <a:ext cx="206405" cy="228632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  <a:ln w="19050">
              <a:solidFill>
                <a:schemeClr val="bg2">
                  <a:lumMod val="1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51" name="CaixaDeTexto 50">
              <a:extLst>
                <a:ext uri="{FF2B5EF4-FFF2-40B4-BE49-F238E27FC236}">
                  <a16:creationId xmlns:a16="http://schemas.microsoft.com/office/drawing/2014/main" id="{A6386923-FE86-4730-A40D-E071502B8622}"/>
                </a:ext>
              </a:extLst>
            </p:cNvPr>
            <p:cNvSpPr txBox="1"/>
            <p:nvPr/>
          </p:nvSpPr>
          <p:spPr>
            <a:xfrm>
              <a:off x="10005824" y="4555837"/>
              <a:ext cx="204487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Not applicable</a:t>
              </a:r>
              <a:endParaRPr lang="pt-BR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pic>
        <p:nvPicPr>
          <p:cNvPr id="7" name="Imagem 6" descr="Gráfico, Gráfico de barras&#10;&#10;Descrição gerada automaticamente">
            <a:extLst>
              <a:ext uri="{FF2B5EF4-FFF2-40B4-BE49-F238E27FC236}">
                <a16:creationId xmlns:a16="http://schemas.microsoft.com/office/drawing/2014/main" id="{BD6FC14D-4229-4E51-AF11-1EFC94B3D640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439"/>
          <a:stretch/>
        </p:blipFill>
        <p:spPr>
          <a:xfrm>
            <a:off x="1534170" y="490330"/>
            <a:ext cx="4668624" cy="5830958"/>
          </a:xfrm>
          <a:prstGeom prst="rect">
            <a:avLst/>
          </a:prstGeom>
        </p:spPr>
      </p:pic>
      <p:sp>
        <p:nvSpPr>
          <p:cNvPr id="36" name="Retângulo 35">
            <a:extLst>
              <a:ext uri="{FF2B5EF4-FFF2-40B4-BE49-F238E27FC236}">
                <a16:creationId xmlns:a16="http://schemas.microsoft.com/office/drawing/2014/main" id="{DC069024-5794-4467-8B1E-907245A4886B}"/>
              </a:ext>
            </a:extLst>
          </p:cNvPr>
          <p:cNvSpPr/>
          <p:nvPr/>
        </p:nvSpPr>
        <p:spPr>
          <a:xfrm>
            <a:off x="147048" y="224971"/>
            <a:ext cx="11885925" cy="3226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5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dditional file 9. </a:t>
            </a:r>
            <a:r>
              <a:rPr lang="en-US" sz="15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OSMIN classification of the methodological quality of studies with and without a translation process</a:t>
            </a:r>
            <a:endParaRPr lang="pt-BR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CaixaDeTexto 36">
            <a:extLst>
              <a:ext uri="{FF2B5EF4-FFF2-40B4-BE49-F238E27FC236}">
                <a16:creationId xmlns:a16="http://schemas.microsoft.com/office/drawing/2014/main" id="{02E28E87-5820-4DB5-ADD7-7D935FCAD004}"/>
              </a:ext>
            </a:extLst>
          </p:cNvPr>
          <p:cNvSpPr txBox="1"/>
          <p:nvPr/>
        </p:nvSpPr>
        <p:spPr>
          <a:xfrm>
            <a:off x="258105" y="6335419"/>
            <a:ext cx="11774868" cy="4924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  <a:spcAft>
                <a:spcPts val="800"/>
              </a:spcAft>
            </a:pPr>
            <a:r>
              <a:rPr lang="en-CA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Note: 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hypotheses testing 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considers 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(criterion validity); structural validity considers (construct validity) and </a:t>
            </a:r>
            <a:r>
              <a:rPr lang="en-US" sz="1300">
                <a:latin typeface="Times New Roman" panose="02020603050405020304" pitchFamily="18" charset="0"/>
                <a:ea typeface="Calibri" panose="020F0502020204030204" pitchFamily="34" charset="0"/>
              </a:rPr>
              <a:t>criterion </a:t>
            </a:r>
            <a:r>
              <a:rPr lang="en-US" sz="1300" smtClean="0">
                <a:latin typeface="Times New Roman" panose="02020603050405020304" pitchFamily="18" charset="0"/>
                <a:ea typeface="Calibri" panose="020F0502020204030204" pitchFamily="34" charset="0"/>
              </a:rPr>
              <a:t>validity considers 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diagnostic performance)</a:t>
            </a:r>
            <a:endParaRPr lang="pt-BR" sz="1300" dirty="0"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sp>
        <p:nvSpPr>
          <p:cNvPr id="38" name="CaixaDeTexto 37">
            <a:extLst>
              <a:ext uri="{FF2B5EF4-FFF2-40B4-BE49-F238E27FC236}">
                <a16:creationId xmlns:a16="http://schemas.microsoft.com/office/drawing/2014/main" id="{8119FB29-639F-4F19-A547-8779693A12CE}"/>
              </a:ext>
            </a:extLst>
          </p:cNvPr>
          <p:cNvSpPr txBox="1"/>
          <p:nvPr/>
        </p:nvSpPr>
        <p:spPr>
          <a:xfrm>
            <a:off x="7357391" y="6253565"/>
            <a:ext cx="264556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</a:t>
            </a:r>
            <a:r>
              <a:rPr lang="pt-B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nslation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B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cess</a:t>
            </a:r>
            <a:endParaRPr lang="pt-B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CaixaDeTexto 38">
            <a:extLst>
              <a:ext uri="{FF2B5EF4-FFF2-40B4-BE49-F238E27FC236}">
                <a16:creationId xmlns:a16="http://schemas.microsoft.com/office/drawing/2014/main" id="{DB5C5379-4487-4E55-9D29-A7F80B84B8E4}"/>
              </a:ext>
            </a:extLst>
          </p:cNvPr>
          <p:cNvSpPr txBox="1"/>
          <p:nvPr/>
        </p:nvSpPr>
        <p:spPr>
          <a:xfrm>
            <a:off x="2328238" y="6182787"/>
            <a:ext cx="264556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nslation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B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cess</a:t>
            </a:r>
            <a:endParaRPr lang="pt-B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1350924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175C7742CF67B94693F52F21A125A5B9" ma:contentTypeVersion="9" ma:contentTypeDescription="Crie um novo documento." ma:contentTypeScope="" ma:versionID="afc06e8ea8857c19f596d7acf31c3260">
  <xsd:schema xmlns:xsd="http://www.w3.org/2001/XMLSchema" xmlns:xs="http://www.w3.org/2001/XMLSchema" xmlns:p="http://schemas.microsoft.com/office/2006/metadata/properties" xmlns:ns3="4302c49d-1ee8-4285-a759-5aa42ebc0471" targetNamespace="http://schemas.microsoft.com/office/2006/metadata/properties" ma:root="true" ma:fieldsID="edaaa1ba61a427f0780317294310f016" ns3:_="">
    <xsd:import namespace="4302c49d-1ee8-4285-a759-5aa42ebc047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302c49d-1ee8-4285-a759-5aa42ebc047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ú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E5CDD9DC-B8CC-4428-A59B-A35AB1B19518}">
  <ds:schemaRefs>
    <ds:schemaRef ds:uri="http://schemas.microsoft.com/office/2006/documentManagement/types"/>
    <ds:schemaRef ds:uri="http://purl.org/dc/terms/"/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http://purl.org/dc/elements/1.1/"/>
    <ds:schemaRef ds:uri="http://schemas.microsoft.com/office/2006/metadata/properties"/>
    <ds:schemaRef ds:uri="4302c49d-1ee8-4285-a759-5aa42ebc0471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8034A061-1054-4EEB-8714-1B690391EE2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302c49d-1ee8-4285-a759-5aa42ebc047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3E31016A-6D52-4285-B55F-7F5286E830EA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64</TotalTime>
  <Words>74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CAMILA OSPINA AYALA</dc:creator>
  <cp:lastModifiedBy>Rita Mattiello</cp:lastModifiedBy>
  <cp:revision>6</cp:revision>
  <dcterms:created xsi:type="dcterms:W3CDTF">2021-10-29T14:39:58Z</dcterms:created>
  <dcterms:modified xsi:type="dcterms:W3CDTF">2022-03-08T20:57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75C7742CF67B94693F52F21A125A5B9</vt:lpwstr>
  </property>
</Properties>
</file>